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4" r:id="rId6"/>
    <p:sldId id="265" r:id="rId7"/>
    <p:sldId id="266" r:id="rId8"/>
    <p:sldId id="267" r:id="rId9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6D1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EE5B2BF-388B-469A-9BEE-C92C11703481}" v="22" dt="2021-08-20T21:06:34.91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3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ta Estrela" userId="7250bf76-ff25-4d45-9f12-2372feb540ff" providerId="ADAL" clId="{B29CEFCF-24BC-4847-988F-086BAE21519A}"/>
    <pc:docChg chg="undo redo custSel addSld modSld modMainMaster">
      <pc:chgData name="Marta Estrela" userId="7250bf76-ff25-4d45-9f12-2372feb540ff" providerId="ADAL" clId="{B29CEFCF-24BC-4847-988F-086BAE21519A}" dt="2021-06-23T13:50:08.684" v="164" actId="26606"/>
      <pc:docMkLst>
        <pc:docMk/>
      </pc:docMkLst>
      <pc:sldChg chg="addSp delSp modSp mod delDesignElem">
        <pc:chgData name="Marta Estrela" userId="7250bf76-ff25-4d45-9f12-2372feb540ff" providerId="ADAL" clId="{B29CEFCF-24BC-4847-988F-086BAE21519A}" dt="2021-06-15T10:47:36.029" v="103" actId="1076"/>
        <pc:sldMkLst>
          <pc:docMk/>
          <pc:sldMk cId="3639856774" sldId="256"/>
        </pc:sldMkLst>
        <pc:spChg chg="mod">
          <ac:chgData name="Marta Estrela" userId="7250bf76-ff25-4d45-9f12-2372feb540ff" providerId="ADAL" clId="{B29CEFCF-24BC-4847-988F-086BAE21519A}" dt="2021-06-15T10:44:17.555" v="78" actId="164"/>
          <ac:spMkLst>
            <pc:docMk/>
            <pc:sldMk cId="3639856774" sldId="256"/>
            <ac:spMk id="12" creationId="{84F1585E-224B-4471-AB59-864DC7B9347D}"/>
          </ac:spMkLst>
        </pc:spChg>
        <pc:spChg chg="add del mod">
          <ac:chgData name="Marta Estrela" userId="7250bf76-ff25-4d45-9f12-2372feb540ff" providerId="ADAL" clId="{B29CEFCF-24BC-4847-988F-086BAE21519A}" dt="2021-06-15T10:45:41.966" v="89"/>
          <ac:spMkLst>
            <pc:docMk/>
            <pc:sldMk cId="3639856774" sldId="256"/>
            <ac:spMk id="16" creationId="{417CDA24-35F8-4540-8C52-3096D6D94949}"/>
          </ac:spMkLst>
        </pc:spChg>
        <pc:spChg chg="add del mod">
          <ac:chgData name="Marta Estrela" userId="7250bf76-ff25-4d45-9f12-2372feb540ff" providerId="ADAL" clId="{B29CEFCF-24BC-4847-988F-086BAE21519A}" dt="2021-06-15T10:45:41.966" v="89"/>
          <ac:spMkLst>
            <pc:docMk/>
            <pc:sldMk cId="3639856774" sldId="256"/>
            <ac:spMk id="18" creationId="{8658BFE0-4E65-4174-9C75-687C94E88273}"/>
          </ac:spMkLst>
        </pc:spChg>
        <pc:spChg chg="del mod">
          <ac:chgData name="Marta Estrela" userId="7250bf76-ff25-4d45-9f12-2372feb540ff" providerId="ADAL" clId="{B29CEFCF-24BC-4847-988F-086BAE21519A}" dt="2021-06-15T10:45:27.348" v="83" actId="478"/>
          <ac:spMkLst>
            <pc:docMk/>
            <pc:sldMk cId="3639856774" sldId="256"/>
            <ac:spMk id="19" creationId="{281CA423-EC11-4403-A8AD-512EAF873716}"/>
          </ac:spMkLst>
        </pc:spChg>
        <pc:spChg chg="add del mod">
          <ac:chgData name="Marta Estrela" userId="7250bf76-ff25-4d45-9f12-2372feb540ff" providerId="ADAL" clId="{B29CEFCF-24BC-4847-988F-086BAE21519A}" dt="2021-06-15T10:45:41.966" v="89"/>
          <ac:spMkLst>
            <pc:docMk/>
            <pc:sldMk cId="3639856774" sldId="256"/>
            <ac:spMk id="20" creationId="{FA75DFED-A0C1-4A83-BE1D-0271C1826EF6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21" creationId="{50DBA0C7-8A25-4E59-AD95-D83B43922142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23" creationId="{A4006BFC-BA99-4B99-B51F-401E511FEBF0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25" creationId="{C1D63995-87B0-4C65-B662-3AF8094CD227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26" creationId="{DB305E81-15CD-4C76-A546-8E4A2211736A}"/>
          </ac:spMkLst>
        </pc:spChg>
        <pc:spChg chg="mod">
          <ac:chgData name="Marta Estrela" userId="7250bf76-ff25-4d45-9f12-2372feb540ff" providerId="ADAL" clId="{B29CEFCF-24BC-4847-988F-086BAE21519A}" dt="2021-06-15T10:47:36.029" v="103" actId="1076"/>
          <ac:spMkLst>
            <pc:docMk/>
            <pc:sldMk cId="3639856774" sldId="256"/>
            <ac:spMk id="27" creationId="{EE16C3ED-B3E9-435F-85FE-21DF8E5EB9E4}"/>
          </ac:spMkLst>
        </pc:spChg>
        <pc:spChg chg="del mod">
          <ac:chgData name="Marta Estrela" userId="7250bf76-ff25-4d45-9f12-2372feb540ff" providerId="ADAL" clId="{B29CEFCF-24BC-4847-988F-086BAE21519A}" dt="2021-06-15T10:45:27.348" v="83" actId="478"/>
          <ac:spMkLst>
            <pc:docMk/>
            <pc:sldMk cId="3639856774" sldId="256"/>
            <ac:spMk id="28" creationId="{C8C0397E-32E4-4926-A96B-4437DF830B4C}"/>
          </ac:spMkLst>
        </pc:spChg>
        <pc:spChg chg="del mod">
          <ac:chgData name="Marta Estrela" userId="7250bf76-ff25-4d45-9f12-2372feb540ff" providerId="ADAL" clId="{B29CEFCF-24BC-4847-988F-086BAE21519A}" dt="2021-06-15T10:45:27.348" v="83" actId="478"/>
          <ac:spMkLst>
            <pc:docMk/>
            <pc:sldMk cId="3639856774" sldId="256"/>
            <ac:spMk id="29" creationId="{2946FA2D-AF4D-447E-9E9D-10C6033C9FCF}"/>
          </ac:spMkLst>
        </pc:spChg>
        <pc:spChg chg="mod">
          <ac:chgData name="Marta Estrela" userId="7250bf76-ff25-4d45-9f12-2372feb540ff" providerId="ADAL" clId="{B29CEFCF-24BC-4847-988F-086BAE21519A}" dt="2021-06-15T10:44:17.555" v="78" actId="164"/>
          <ac:spMkLst>
            <pc:docMk/>
            <pc:sldMk cId="3639856774" sldId="256"/>
            <ac:spMk id="30" creationId="{CDDA1624-1229-4770-BE59-1077DE950367}"/>
          </ac:spMkLst>
        </pc:spChg>
        <pc:spChg chg="del mod">
          <ac:chgData name="Marta Estrela" userId="7250bf76-ff25-4d45-9f12-2372feb540ff" providerId="ADAL" clId="{B29CEFCF-24BC-4847-988F-086BAE21519A}" dt="2021-06-15T10:45:27.348" v="83" actId="478"/>
          <ac:spMkLst>
            <pc:docMk/>
            <pc:sldMk cId="3639856774" sldId="256"/>
            <ac:spMk id="31" creationId="{A68B8221-B2D5-4540-9B3E-6FA0EB1E3903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32" creationId="{3A9BDAB2-AC9D-4232-AF0F-9292E7253A41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33" creationId="{83855EAA-7BC4-4AD2-A4E0-774E43AE4F2D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34" creationId="{9237CD84-D6A2-4C15-8E5D-39825C6AA6E4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35" creationId="{C51DA028-FE4D-4AD5-9C86-A9E91FFE3914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36" creationId="{688667CD-C7EF-42D1-99E7-B28605B17AAF}"/>
          </ac:spMkLst>
        </pc:spChg>
        <pc:spChg chg="del mod">
          <ac:chgData name="Marta Estrela" userId="7250bf76-ff25-4d45-9f12-2372feb540ff" providerId="ADAL" clId="{B29CEFCF-24BC-4847-988F-086BAE21519A}" dt="2021-06-15T10:45:24.240" v="82" actId="478"/>
          <ac:spMkLst>
            <pc:docMk/>
            <pc:sldMk cId="3639856774" sldId="256"/>
            <ac:spMk id="37" creationId="{1857D528-0445-49D7-9846-BDD5EA174D7B}"/>
          </ac:spMkLst>
        </pc:spChg>
        <pc:spChg chg="add">
          <ac:chgData name="Marta Estrela" userId="7250bf76-ff25-4d45-9f12-2372feb540ff" providerId="ADAL" clId="{B29CEFCF-24BC-4847-988F-086BAE21519A}" dt="2021-06-15T10:45:49.499" v="90" actId="26606"/>
          <ac:spMkLst>
            <pc:docMk/>
            <pc:sldMk cId="3639856774" sldId="256"/>
            <ac:spMk id="38" creationId="{32BC26D8-82FB-445E-AA49-62A77D7C1EE0}"/>
          </ac:spMkLst>
        </pc:spChg>
        <pc:spChg chg="add">
          <ac:chgData name="Marta Estrela" userId="7250bf76-ff25-4d45-9f12-2372feb540ff" providerId="ADAL" clId="{B29CEFCF-24BC-4847-988F-086BAE21519A}" dt="2021-06-15T10:45:49.499" v="90" actId="26606"/>
          <ac:spMkLst>
            <pc:docMk/>
            <pc:sldMk cId="3639856774" sldId="256"/>
            <ac:spMk id="39" creationId="{CB44330D-EA18-4254-AA95-EB49948539B8}"/>
          </ac:spMkLst>
        </pc:spChg>
        <pc:grpChg chg="add mod">
          <ac:chgData name="Marta Estrela" userId="7250bf76-ff25-4d45-9f12-2372feb540ff" providerId="ADAL" clId="{B29CEFCF-24BC-4847-988F-086BAE21519A}" dt="2021-06-15T10:45:49.499" v="90" actId="26606"/>
          <ac:grpSpMkLst>
            <pc:docMk/>
            <pc:sldMk cId="3639856774" sldId="256"/>
            <ac:grpSpMk id="2" creationId="{EB4BF057-EA90-448B-901C-05AE0C42A991}"/>
          </ac:grpSpMkLst>
        </pc:grpChg>
        <pc:picChg chg="add del mod">
          <ac:chgData name="Marta Estrela" userId="7250bf76-ff25-4d45-9f12-2372feb540ff" providerId="ADAL" clId="{B29CEFCF-24BC-4847-988F-086BAE21519A}" dt="2021-06-07T13:49:37.895" v="29"/>
          <ac:picMkLst>
            <pc:docMk/>
            <pc:sldMk cId="3639856774" sldId="256"/>
            <ac:picMk id="3" creationId="{F5739F52-D275-485C-AD55-0330D3C7B968}"/>
          </ac:picMkLst>
        </pc:picChg>
        <pc:picChg chg="mod">
          <ac:chgData name="Marta Estrela" userId="7250bf76-ff25-4d45-9f12-2372feb540ff" providerId="ADAL" clId="{B29CEFCF-24BC-4847-988F-086BAE21519A}" dt="2021-06-15T10:44:17.555" v="78" actId="164"/>
          <ac:picMkLst>
            <pc:docMk/>
            <pc:sldMk cId="3639856774" sldId="256"/>
            <ac:picMk id="5" creationId="{C9380676-FF0D-47F8-9CDD-44213D3EBF7E}"/>
          </ac:picMkLst>
        </pc:picChg>
        <pc:picChg chg="add del mod ord">
          <ac:chgData name="Marta Estrela" userId="7250bf76-ff25-4d45-9f12-2372feb540ff" providerId="ADAL" clId="{B29CEFCF-24BC-4847-988F-086BAE21519A}" dt="2021-06-15T10:45:24.240" v="82" actId="478"/>
          <ac:picMkLst>
            <pc:docMk/>
            <pc:sldMk cId="3639856774" sldId="256"/>
            <ac:picMk id="6" creationId="{91CC455E-5E6A-4DE0-AE4C-1B03E81107AB}"/>
          </ac:picMkLst>
        </pc:picChg>
        <pc:picChg chg="del mod">
          <ac:chgData name="Marta Estrela" userId="7250bf76-ff25-4d45-9f12-2372feb540ff" providerId="ADAL" clId="{B29CEFCF-24BC-4847-988F-086BAE21519A}" dt="2021-06-15T10:45:27.348" v="83" actId="478"/>
          <ac:picMkLst>
            <pc:docMk/>
            <pc:sldMk cId="3639856774" sldId="256"/>
            <ac:picMk id="7" creationId="{4AF3076E-DD31-44BE-B219-2ECFA12D3B29}"/>
          </ac:picMkLst>
        </pc:picChg>
        <pc:picChg chg="del mod">
          <ac:chgData name="Marta Estrela" userId="7250bf76-ff25-4d45-9f12-2372feb540ff" providerId="ADAL" clId="{B29CEFCF-24BC-4847-988F-086BAE21519A}" dt="2021-06-07T13:58:19.131" v="36" actId="478"/>
          <ac:picMkLst>
            <pc:docMk/>
            <pc:sldMk cId="3639856774" sldId="256"/>
            <ac:picMk id="9" creationId="{F55025EF-91AD-4FD2-9D28-9B90D4F55388}"/>
          </ac:picMkLst>
        </pc:picChg>
        <pc:picChg chg="add del mod modCrop">
          <ac:chgData name="Marta Estrela" userId="7250bf76-ff25-4d45-9f12-2372feb540ff" providerId="ADAL" clId="{B29CEFCF-24BC-4847-988F-086BAE21519A}" dt="2021-06-15T10:45:24.240" v="82" actId="478"/>
          <ac:picMkLst>
            <pc:docMk/>
            <pc:sldMk cId="3639856774" sldId="256"/>
            <ac:picMk id="10" creationId="{A471FFF3-F72E-493B-B40D-2ACAF4DEAF5D}"/>
          </ac:picMkLst>
        </pc:picChg>
        <pc:picChg chg="add del mod">
          <ac:chgData name="Marta Estrela" userId="7250bf76-ff25-4d45-9f12-2372feb540ff" providerId="ADAL" clId="{B29CEFCF-24BC-4847-988F-086BAE21519A}" dt="2021-06-15T10:45:24.240" v="82" actId="478"/>
          <ac:picMkLst>
            <pc:docMk/>
            <pc:sldMk cId="3639856774" sldId="256"/>
            <ac:picMk id="11" creationId="{4FEA127D-AC08-4787-A3A9-C3D52F56B7D6}"/>
          </ac:picMkLst>
        </pc:picChg>
      </pc:sldChg>
      <pc:sldChg chg="addSp delSp modSp add mod delDesignElem">
        <pc:chgData name="Marta Estrela" userId="7250bf76-ff25-4d45-9f12-2372feb540ff" providerId="ADAL" clId="{B29CEFCF-24BC-4847-988F-086BAE21519A}" dt="2021-06-15T10:51:25.809" v="152" actId="26606"/>
        <pc:sldMkLst>
          <pc:docMk/>
          <pc:sldMk cId="135140757" sldId="257"/>
        </pc:sldMkLst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135140757" sldId="257"/>
            <ac:spMk id="16" creationId="{417CDA24-35F8-4540-8C52-3096D6D94949}"/>
          </ac:spMkLst>
        </pc:spChg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135140757" sldId="257"/>
            <ac:spMk id="18" creationId="{8658BFE0-4E65-4174-9C75-687C94E88273}"/>
          </ac:spMkLst>
        </pc:spChg>
        <pc:spChg chg="del mod">
          <ac:chgData name="Marta Estrela" userId="7250bf76-ff25-4d45-9f12-2372feb540ff" providerId="ADAL" clId="{B29CEFCF-24BC-4847-988F-086BAE21519A}" dt="2021-06-15T10:47:02.552" v="98" actId="478"/>
          <ac:spMkLst>
            <pc:docMk/>
            <pc:sldMk cId="135140757" sldId="257"/>
            <ac:spMk id="19" creationId="{281CA423-EC11-4403-A8AD-512EAF873716}"/>
          </ac:spMkLst>
        </pc:spChg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135140757" sldId="257"/>
            <ac:spMk id="20" creationId="{FA75DFED-A0C1-4A83-BE1D-0271C1826EF6}"/>
          </ac:spMkLst>
        </pc:spChg>
        <pc:spChg chg="del">
          <ac:chgData name="Marta Estrela" userId="7250bf76-ff25-4d45-9f12-2372feb540ff" providerId="ADAL" clId="{B29CEFCF-24BC-4847-988F-086BAE21519A}" dt="2021-06-15T10:46:01.123" v="91" actId="478"/>
          <ac:spMkLst>
            <pc:docMk/>
            <pc:sldMk cId="135140757" sldId="257"/>
            <ac:spMk id="21" creationId="{50DBA0C7-8A25-4E59-AD95-D83B43922142}"/>
          </ac:spMkLst>
        </pc:spChg>
        <pc:spChg chg="del">
          <ac:chgData name="Marta Estrela" userId="7250bf76-ff25-4d45-9f12-2372feb540ff" providerId="ADAL" clId="{B29CEFCF-24BC-4847-988F-086BAE21519A}" dt="2021-06-15T10:46:05.663" v="92" actId="478"/>
          <ac:spMkLst>
            <pc:docMk/>
            <pc:sldMk cId="135140757" sldId="257"/>
            <ac:spMk id="23" creationId="{A4006BFC-BA99-4B99-B51F-401E511FEBF0}"/>
          </ac:spMkLst>
        </pc:spChg>
        <pc:spChg chg="del">
          <ac:chgData name="Marta Estrela" userId="7250bf76-ff25-4d45-9f12-2372feb540ff" providerId="ADAL" clId="{B29CEFCF-24BC-4847-988F-086BAE21519A}" dt="2021-06-15T10:46:01.123" v="91" actId="478"/>
          <ac:spMkLst>
            <pc:docMk/>
            <pc:sldMk cId="135140757" sldId="257"/>
            <ac:spMk id="25" creationId="{C1D63995-87B0-4C65-B662-3AF8094CD227}"/>
          </ac:spMkLst>
        </pc:spChg>
        <pc:spChg chg="del">
          <ac:chgData name="Marta Estrela" userId="7250bf76-ff25-4d45-9f12-2372feb540ff" providerId="ADAL" clId="{B29CEFCF-24BC-4847-988F-086BAE21519A}" dt="2021-06-15T10:46:09.546" v="94" actId="478"/>
          <ac:spMkLst>
            <pc:docMk/>
            <pc:sldMk cId="135140757" sldId="257"/>
            <ac:spMk id="26" creationId="{DB305E81-15CD-4C76-A546-8E4A2211736A}"/>
          </ac:spMkLst>
        </pc:spChg>
        <pc:spChg chg="mod">
          <ac:chgData name="Marta Estrela" userId="7250bf76-ff25-4d45-9f12-2372feb540ff" providerId="ADAL" clId="{B29CEFCF-24BC-4847-988F-086BAE21519A}" dt="2021-06-15T10:51:09.834" v="150" actId="164"/>
          <ac:spMkLst>
            <pc:docMk/>
            <pc:sldMk cId="135140757" sldId="257"/>
            <ac:spMk id="28" creationId="{C8C0397E-32E4-4926-A96B-4437DF830B4C}"/>
          </ac:spMkLst>
        </pc:spChg>
        <pc:spChg chg="mod">
          <ac:chgData name="Marta Estrela" userId="7250bf76-ff25-4d45-9f12-2372feb540ff" providerId="ADAL" clId="{B29CEFCF-24BC-4847-988F-086BAE21519A}" dt="2021-06-15T10:51:09.834" v="150" actId="164"/>
          <ac:spMkLst>
            <pc:docMk/>
            <pc:sldMk cId="135140757" sldId="257"/>
            <ac:spMk id="29" creationId="{2946FA2D-AF4D-447E-9E9D-10C6033C9FCF}"/>
          </ac:spMkLst>
        </pc:spChg>
        <pc:spChg chg="mod">
          <ac:chgData name="Marta Estrela" userId="7250bf76-ff25-4d45-9f12-2372feb540ff" providerId="ADAL" clId="{B29CEFCF-24BC-4847-988F-086BAE21519A}" dt="2021-06-15T10:51:09.834" v="150" actId="164"/>
          <ac:spMkLst>
            <pc:docMk/>
            <pc:sldMk cId="135140757" sldId="257"/>
            <ac:spMk id="31" creationId="{A68B8221-B2D5-4540-9B3E-6FA0EB1E3903}"/>
          </ac:spMkLst>
        </pc:spChg>
        <pc:spChg chg="del">
          <ac:chgData name="Marta Estrela" userId="7250bf76-ff25-4d45-9f12-2372feb540ff" providerId="ADAL" clId="{B29CEFCF-24BC-4847-988F-086BAE21519A}" dt="2021-06-15T10:46:01.123" v="91" actId="478"/>
          <ac:spMkLst>
            <pc:docMk/>
            <pc:sldMk cId="135140757" sldId="257"/>
            <ac:spMk id="32" creationId="{3A9BDAB2-AC9D-4232-AF0F-9292E7253A41}"/>
          </ac:spMkLst>
        </pc:spChg>
        <pc:spChg chg="del">
          <ac:chgData name="Marta Estrela" userId="7250bf76-ff25-4d45-9f12-2372feb540ff" providerId="ADAL" clId="{B29CEFCF-24BC-4847-988F-086BAE21519A}" dt="2021-06-15T10:46:01.123" v="91" actId="478"/>
          <ac:spMkLst>
            <pc:docMk/>
            <pc:sldMk cId="135140757" sldId="257"/>
            <ac:spMk id="33" creationId="{83855EAA-7BC4-4AD2-A4E0-774E43AE4F2D}"/>
          </ac:spMkLst>
        </pc:spChg>
        <pc:spChg chg="del">
          <ac:chgData name="Marta Estrela" userId="7250bf76-ff25-4d45-9f12-2372feb540ff" providerId="ADAL" clId="{B29CEFCF-24BC-4847-988F-086BAE21519A}" dt="2021-06-15T10:46:01.123" v="91" actId="478"/>
          <ac:spMkLst>
            <pc:docMk/>
            <pc:sldMk cId="135140757" sldId="257"/>
            <ac:spMk id="34" creationId="{9237CD84-D6A2-4C15-8E5D-39825C6AA6E4}"/>
          </ac:spMkLst>
        </pc:spChg>
        <pc:spChg chg="del">
          <ac:chgData name="Marta Estrela" userId="7250bf76-ff25-4d45-9f12-2372feb540ff" providerId="ADAL" clId="{B29CEFCF-24BC-4847-988F-086BAE21519A}" dt="2021-06-15T10:46:05.663" v="92" actId="478"/>
          <ac:spMkLst>
            <pc:docMk/>
            <pc:sldMk cId="135140757" sldId="257"/>
            <ac:spMk id="35" creationId="{C51DA028-FE4D-4AD5-9C86-A9E91FFE3914}"/>
          </ac:spMkLst>
        </pc:spChg>
        <pc:spChg chg="del">
          <ac:chgData name="Marta Estrela" userId="7250bf76-ff25-4d45-9f12-2372feb540ff" providerId="ADAL" clId="{B29CEFCF-24BC-4847-988F-086BAE21519A}" dt="2021-06-15T10:46:05.663" v="92" actId="478"/>
          <ac:spMkLst>
            <pc:docMk/>
            <pc:sldMk cId="135140757" sldId="257"/>
            <ac:spMk id="36" creationId="{688667CD-C7EF-42D1-99E7-B28605B17AAF}"/>
          </ac:spMkLst>
        </pc:spChg>
        <pc:spChg chg="del">
          <ac:chgData name="Marta Estrela" userId="7250bf76-ff25-4d45-9f12-2372feb540ff" providerId="ADAL" clId="{B29CEFCF-24BC-4847-988F-086BAE21519A}" dt="2021-06-15T10:46:05.663" v="92" actId="478"/>
          <ac:spMkLst>
            <pc:docMk/>
            <pc:sldMk cId="135140757" sldId="257"/>
            <ac:spMk id="37" creationId="{1857D528-0445-49D7-9846-BDD5EA174D7B}"/>
          </ac:spMkLst>
        </pc:spChg>
        <pc:spChg chg="add del mod">
          <ac:chgData name="Marta Estrela" userId="7250bf76-ff25-4d45-9f12-2372feb540ff" providerId="ADAL" clId="{B29CEFCF-24BC-4847-988F-086BAE21519A}" dt="2021-06-15T10:47:44.153" v="105" actId="478"/>
          <ac:spMkLst>
            <pc:docMk/>
            <pc:sldMk cId="135140757" sldId="257"/>
            <ac:spMk id="38" creationId="{7F254E03-C648-4AE1-BE4F-33D47F37F570}"/>
          </ac:spMkLst>
        </pc:spChg>
        <pc:spChg chg="add mod">
          <ac:chgData name="Marta Estrela" userId="7250bf76-ff25-4d45-9f12-2372feb540ff" providerId="ADAL" clId="{B29CEFCF-24BC-4847-988F-086BAE21519A}" dt="2021-06-15T10:51:09.834" v="150" actId="164"/>
          <ac:spMkLst>
            <pc:docMk/>
            <pc:sldMk cId="135140757" sldId="257"/>
            <ac:spMk id="39" creationId="{D90DBF12-FA02-483A-B180-1055981C0536}"/>
          </ac:spMkLst>
        </pc:spChg>
        <pc:spChg chg="add">
          <ac:chgData name="Marta Estrela" userId="7250bf76-ff25-4d45-9f12-2372feb540ff" providerId="ADAL" clId="{B29CEFCF-24BC-4847-988F-086BAE21519A}" dt="2021-06-15T10:51:25.809" v="152" actId="26606"/>
          <ac:spMkLst>
            <pc:docMk/>
            <pc:sldMk cId="135140757" sldId="257"/>
            <ac:spMk id="44" creationId="{32BC26D8-82FB-445E-AA49-62A77D7C1EE0}"/>
          </ac:spMkLst>
        </pc:spChg>
        <pc:spChg chg="add">
          <ac:chgData name="Marta Estrela" userId="7250bf76-ff25-4d45-9f12-2372feb540ff" providerId="ADAL" clId="{B29CEFCF-24BC-4847-988F-086BAE21519A}" dt="2021-06-15T10:51:25.809" v="152" actId="26606"/>
          <ac:spMkLst>
            <pc:docMk/>
            <pc:sldMk cId="135140757" sldId="257"/>
            <ac:spMk id="46" creationId="{CB44330D-EA18-4254-AA95-EB49948539B8}"/>
          </ac:spMkLst>
        </pc:spChg>
        <pc:grpChg chg="del">
          <ac:chgData name="Marta Estrela" userId="7250bf76-ff25-4d45-9f12-2372feb540ff" providerId="ADAL" clId="{B29CEFCF-24BC-4847-988F-086BAE21519A}" dt="2021-06-15T10:46:01.123" v="91" actId="478"/>
          <ac:grpSpMkLst>
            <pc:docMk/>
            <pc:sldMk cId="135140757" sldId="257"/>
            <ac:grpSpMk id="2" creationId="{EB4BF057-EA90-448B-901C-05AE0C42A991}"/>
          </ac:grpSpMkLst>
        </pc:grpChg>
        <pc:grpChg chg="add mod">
          <ac:chgData name="Marta Estrela" userId="7250bf76-ff25-4d45-9f12-2372feb540ff" providerId="ADAL" clId="{B29CEFCF-24BC-4847-988F-086BAE21519A}" dt="2021-06-15T10:51:25.809" v="152" actId="26606"/>
          <ac:grpSpMkLst>
            <pc:docMk/>
            <pc:sldMk cId="135140757" sldId="257"/>
            <ac:grpSpMk id="3" creationId="{0B95B698-7486-4CD3-BD18-79EFA4A9159A}"/>
          </ac:grpSpMkLst>
        </pc:grpChg>
        <pc:picChg chg="del">
          <ac:chgData name="Marta Estrela" userId="7250bf76-ff25-4d45-9f12-2372feb540ff" providerId="ADAL" clId="{B29CEFCF-24BC-4847-988F-086BAE21519A}" dt="2021-06-15T10:46:01.123" v="91" actId="478"/>
          <ac:picMkLst>
            <pc:docMk/>
            <pc:sldMk cId="135140757" sldId="257"/>
            <ac:picMk id="6" creationId="{91CC455E-5E6A-4DE0-AE4C-1B03E81107AB}"/>
          </ac:picMkLst>
        </pc:picChg>
        <pc:picChg chg="mod">
          <ac:chgData name="Marta Estrela" userId="7250bf76-ff25-4d45-9f12-2372feb540ff" providerId="ADAL" clId="{B29CEFCF-24BC-4847-988F-086BAE21519A}" dt="2021-06-15T10:51:09.834" v="150" actId="164"/>
          <ac:picMkLst>
            <pc:docMk/>
            <pc:sldMk cId="135140757" sldId="257"/>
            <ac:picMk id="7" creationId="{4AF3076E-DD31-44BE-B219-2ECFA12D3B29}"/>
          </ac:picMkLst>
        </pc:picChg>
        <pc:picChg chg="del">
          <ac:chgData name="Marta Estrela" userId="7250bf76-ff25-4d45-9f12-2372feb540ff" providerId="ADAL" clId="{B29CEFCF-24BC-4847-988F-086BAE21519A}" dt="2021-06-15T10:46:05.663" v="92" actId="478"/>
          <ac:picMkLst>
            <pc:docMk/>
            <pc:sldMk cId="135140757" sldId="257"/>
            <ac:picMk id="10" creationId="{A471FFF3-F72E-493B-B40D-2ACAF4DEAF5D}"/>
          </ac:picMkLst>
        </pc:picChg>
        <pc:picChg chg="del">
          <ac:chgData name="Marta Estrela" userId="7250bf76-ff25-4d45-9f12-2372feb540ff" providerId="ADAL" clId="{B29CEFCF-24BC-4847-988F-086BAE21519A}" dt="2021-06-15T10:46:06.875" v="93" actId="478"/>
          <ac:picMkLst>
            <pc:docMk/>
            <pc:sldMk cId="135140757" sldId="257"/>
            <ac:picMk id="11" creationId="{4FEA127D-AC08-4787-A3A9-C3D52F56B7D6}"/>
          </ac:picMkLst>
        </pc:picChg>
      </pc:sldChg>
      <pc:sldChg chg="addSp delSp modSp add mod delDesignElem">
        <pc:chgData name="Marta Estrela" userId="7250bf76-ff25-4d45-9f12-2372feb540ff" providerId="ADAL" clId="{B29CEFCF-24BC-4847-988F-086BAE21519A}" dt="2021-06-15T10:51:32.239" v="153" actId="26606"/>
        <pc:sldMkLst>
          <pc:docMk/>
          <pc:sldMk cId="2996517111" sldId="258"/>
        </pc:sldMkLst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2996517111" sldId="258"/>
            <ac:spMk id="16" creationId="{417CDA24-35F8-4540-8C52-3096D6D94949}"/>
          </ac:spMkLst>
        </pc:spChg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2996517111" sldId="258"/>
            <ac:spMk id="18" creationId="{8658BFE0-4E65-4174-9C75-687C94E88273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19" creationId="{281CA423-EC11-4403-A8AD-512EAF873716}"/>
          </ac:spMkLst>
        </pc:spChg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2996517111" sldId="258"/>
            <ac:spMk id="20" creationId="{FA75DFED-A0C1-4A83-BE1D-0271C1826EF6}"/>
          </ac:spMkLst>
        </pc:spChg>
        <pc:spChg chg="del">
          <ac:chgData name="Marta Estrela" userId="7250bf76-ff25-4d45-9f12-2372feb540ff" providerId="ADAL" clId="{B29CEFCF-24BC-4847-988F-086BAE21519A}" dt="2021-06-15T10:48:43.714" v="117" actId="478"/>
          <ac:spMkLst>
            <pc:docMk/>
            <pc:sldMk cId="2996517111" sldId="258"/>
            <ac:spMk id="21" creationId="{50DBA0C7-8A25-4E59-AD95-D83B43922142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23" creationId="{A4006BFC-BA99-4B99-B51F-401E511FEBF0}"/>
          </ac:spMkLst>
        </pc:spChg>
        <pc:spChg chg="del">
          <ac:chgData name="Marta Estrela" userId="7250bf76-ff25-4d45-9f12-2372feb540ff" providerId="ADAL" clId="{B29CEFCF-24BC-4847-988F-086BAE21519A}" dt="2021-06-15T10:48:28.019" v="114" actId="478"/>
          <ac:spMkLst>
            <pc:docMk/>
            <pc:sldMk cId="2996517111" sldId="258"/>
            <ac:spMk id="25" creationId="{C1D63995-87B0-4C65-B662-3AF8094CD227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26" creationId="{DB305E81-15CD-4C76-A546-8E4A2211736A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28" creationId="{C8C0397E-32E4-4926-A96B-4437DF830B4C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29" creationId="{2946FA2D-AF4D-447E-9E9D-10C6033C9FCF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31" creationId="{A68B8221-B2D5-4540-9B3E-6FA0EB1E3903}"/>
          </ac:spMkLst>
        </pc:spChg>
        <pc:spChg chg="mod">
          <ac:chgData name="Marta Estrela" userId="7250bf76-ff25-4d45-9f12-2372feb540ff" providerId="ADAL" clId="{B29CEFCF-24BC-4847-988F-086BAE21519A}" dt="2021-06-15T10:51:19.675" v="151" actId="164"/>
          <ac:spMkLst>
            <pc:docMk/>
            <pc:sldMk cId="2996517111" sldId="258"/>
            <ac:spMk id="32" creationId="{3A9BDAB2-AC9D-4232-AF0F-9292E7253A41}"/>
          </ac:spMkLst>
        </pc:spChg>
        <pc:spChg chg="mod">
          <ac:chgData name="Marta Estrela" userId="7250bf76-ff25-4d45-9f12-2372feb540ff" providerId="ADAL" clId="{B29CEFCF-24BC-4847-988F-086BAE21519A}" dt="2021-06-15T10:51:19.675" v="151" actId="164"/>
          <ac:spMkLst>
            <pc:docMk/>
            <pc:sldMk cId="2996517111" sldId="258"/>
            <ac:spMk id="33" creationId="{83855EAA-7BC4-4AD2-A4E0-774E43AE4F2D}"/>
          </ac:spMkLst>
        </pc:spChg>
        <pc:spChg chg="mod">
          <ac:chgData name="Marta Estrela" userId="7250bf76-ff25-4d45-9f12-2372feb540ff" providerId="ADAL" clId="{B29CEFCF-24BC-4847-988F-086BAE21519A}" dt="2021-06-15T10:51:19.675" v="151" actId="164"/>
          <ac:spMkLst>
            <pc:docMk/>
            <pc:sldMk cId="2996517111" sldId="258"/>
            <ac:spMk id="34" creationId="{9237CD84-D6A2-4C15-8E5D-39825C6AA6E4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35" creationId="{C51DA028-FE4D-4AD5-9C86-A9E91FFE3914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36" creationId="{688667CD-C7EF-42D1-99E7-B28605B17AAF}"/>
          </ac:spMkLst>
        </pc:spChg>
        <pc:spChg chg="del">
          <ac:chgData name="Marta Estrela" userId="7250bf76-ff25-4d45-9f12-2372feb540ff" providerId="ADAL" clId="{B29CEFCF-24BC-4847-988F-086BAE21519A}" dt="2021-06-15T10:48:20.639" v="113" actId="478"/>
          <ac:spMkLst>
            <pc:docMk/>
            <pc:sldMk cId="2996517111" sldId="258"/>
            <ac:spMk id="37" creationId="{1857D528-0445-49D7-9846-BDD5EA174D7B}"/>
          </ac:spMkLst>
        </pc:spChg>
        <pc:spChg chg="add del mod">
          <ac:chgData name="Marta Estrela" userId="7250bf76-ff25-4d45-9f12-2372feb540ff" providerId="ADAL" clId="{B29CEFCF-24BC-4847-988F-086BAE21519A}" dt="2021-06-15T10:48:52.054" v="123"/>
          <ac:spMkLst>
            <pc:docMk/>
            <pc:sldMk cId="2996517111" sldId="258"/>
            <ac:spMk id="38" creationId="{47B39F3B-0F09-4687-A754-175BD8E7F657}"/>
          </ac:spMkLst>
        </pc:spChg>
        <pc:spChg chg="add mod">
          <ac:chgData name="Marta Estrela" userId="7250bf76-ff25-4d45-9f12-2372feb540ff" providerId="ADAL" clId="{B29CEFCF-24BC-4847-988F-086BAE21519A}" dt="2021-06-15T10:51:19.675" v="151" actId="164"/>
          <ac:spMkLst>
            <pc:docMk/>
            <pc:sldMk cId="2996517111" sldId="258"/>
            <ac:spMk id="39" creationId="{BC9204D6-9469-4A28-8697-4E02D3A5C987}"/>
          </ac:spMkLst>
        </pc:spChg>
        <pc:spChg chg="add mod">
          <ac:chgData name="Marta Estrela" userId="7250bf76-ff25-4d45-9f12-2372feb540ff" providerId="ADAL" clId="{B29CEFCF-24BC-4847-988F-086BAE21519A}" dt="2021-06-15T10:51:19.675" v="151" actId="164"/>
          <ac:spMkLst>
            <pc:docMk/>
            <pc:sldMk cId="2996517111" sldId="258"/>
            <ac:spMk id="40" creationId="{41BCBF16-9A98-4D90-8D2B-45BE054A819F}"/>
          </ac:spMkLst>
        </pc:spChg>
        <pc:spChg chg="add">
          <ac:chgData name="Marta Estrela" userId="7250bf76-ff25-4d45-9f12-2372feb540ff" providerId="ADAL" clId="{B29CEFCF-24BC-4847-988F-086BAE21519A}" dt="2021-06-15T10:51:32.239" v="153" actId="26606"/>
          <ac:spMkLst>
            <pc:docMk/>
            <pc:sldMk cId="2996517111" sldId="258"/>
            <ac:spMk id="45" creationId="{32BC26D8-82FB-445E-AA49-62A77D7C1EE0}"/>
          </ac:spMkLst>
        </pc:spChg>
        <pc:spChg chg="add">
          <ac:chgData name="Marta Estrela" userId="7250bf76-ff25-4d45-9f12-2372feb540ff" providerId="ADAL" clId="{B29CEFCF-24BC-4847-988F-086BAE21519A}" dt="2021-06-15T10:51:32.239" v="153" actId="26606"/>
          <ac:spMkLst>
            <pc:docMk/>
            <pc:sldMk cId="2996517111" sldId="258"/>
            <ac:spMk id="47" creationId="{CB44330D-EA18-4254-AA95-EB49948539B8}"/>
          </ac:spMkLst>
        </pc:spChg>
        <pc:grpChg chg="del">
          <ac:chgData name="Marta Estrela" userId="7250bf76-ff25-4d45-9f12-2372feb540ff" providerId="ADAL" clId="{B29CEFCF-24BC-4847-988F-086BAE21519A}" dt="2021-06-15T10:48:28.019" v="114" actId="478"/>
          <ac:grpSpMkLst>
            <pc:docMk/>
            <pc:sldMk cId="2996517111" sldId="258"/>
            <ac:grpSpMk id="2" creationId="{EB4BF057-EA90-448B-901C-05AE0C42A991}"/>
          </ac:grpSpMkLst>
        </pc:grpChg>
        <pc:grpChg chg="add mod">
          <ac:chgData name="Marta Estrela" userId="7250bf76-ff25-4d45-9f12-2372feb540ff" providerId="ADAL" clId="{B29CEFCF-24BC-4847-988F-086BAE21519A}" dt="2021-06-15T10:51:32.239" v="153" actId="26606"/>
          <ac:grpSpMkLst>
            <pc:docMk/>
            <pc:sldMk cId="2996517111" sldId="258"/>
            <ac:grpSpMk id="3" creationId="{1885CFBC-453D-43DA-A843-46B188C8D299}"/>
          </ac:grpSpMkLst>
        </pc:grpChg>
        <pc:picChg chg="mod">
          <ac:chgData name="Marta Estrela" userId="7250bf76-ff25-4d45-9f12-2372feb540ff" providerId="ADAL" clId="{B29CEFCF-24BC-4847-988F-086BAE21519A}" dt="2021-06-15T10:51:19.675" v="151" actId="164"/>
          <ac:picMkLst>
            <pc:docMk/>
            <pc:sldMk cId="2996517111" sldId="258"/>
            <ac:picMk id="6" creationId="{91CC455E-5E6A-4DE0-AE4C-1B03E81107AB}"/>
          </ac:picMkLst>
        </pc:picChg>
        <pc:picChg chg="del">
          <ac:chgData name="Marta Estrela" userId="7250bf76-ff25-4d45-9f12-2372feb540ff" providerId="ADAL" clId="{B29CEFCF-24BC-4847-988F-086BAE21519A}" dt="2021-06-15T10:48:20.639" v="113" actId="478"/>
          <ac:picMkLst>
            <pc:docMk/>
            <pc:sldMk cId="2996517111" sldId="258"/>
            <ac:picMk id="7" creationId="{4AF3076E-DD31-44BE-B219-2ECFA12D3B29}"/>
          </ac:picMkLst>
        </pc:picChg>
        <pc:picChg chg="del">
          <ac:chgData name="Marta Estrela" userId="7250bf76-ff25-4d45-9f12-2372feb540ff" providerId="ADAL" clId="{B29CEFCF-24BC-4847-988F-086BAE21519A}" dt="2021-06-15T10:48:20.639" v="113" actId="478"/>
          <ac:picMkLst>
            <pc:docMk/>
            <pc:sldMk cId="2996517111" sldId="258"/>
            <ac:picMk id="10" creationId="{A471FFF3-F72E-493B-B40D-2ACAF4DEAF5D}"/>
          </ac:picMkLst>
        </pc:picChg>
        <pc:picChg chg="del">
          <ac:chgData name="Marta Estrela" userId="7250bf76-ff25-4d45-9f12-2372feb540ff" providerId="ADAL" clId="{B29CEFCF-24BC-4847-988F-086BAE21519A}" dt="2021-06-15T10:48:20.639" v="113" actId="478"/>
          <ac:picMkLst>
            <pc:docMk/>
            <pc:sldMk cId="2996517111" sldId="258"/>
            <ac:picMk id="11" creationId="{4FEA127D-AC08-4787-A3A9-C3D52F56B7D6}"/>
          </ac:picMkLst>
        </pc:picChg>
      </pc:sldChg>
      <pc:sldChg chg="addSp delSp modSp add mod delDesignElem">
        <pc:chgData name="Marta Estrela" userId="7250bf76-ff25-4d45-9f12-2372feb540ff" providerId="ADAL" clId="{B29CEFCF-24BC-4847-988F-086BAE21519A}" dt="2021-06-15T10:50:44.034" v="149" actId="26606"/>
        <pc:sldMkLst>
          <pc:docMk/>
          <pc:sldMk cId="3087812012" sldId="259"/>
        </pc:sldMkLst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3087812012" sldId="259"/>
            <ac:spMk id="16" creationId="{417CDA24-35F8-4540-8C52-3096D6D94949}"/>
          </ac:spMkLst>
        </pc:spChg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3087812012" sldId="259"/>
            <ac:spMk id="18" creationId="{8658BFE0-4E65-4174-9C75-687C94E88273}"/>
          </ac:spMkLst>
        </pc:spChg>
        <pc:spChg chg="del">
          <ac:chgData name="Marta Estrela" userId="7250bf76-ff25-4d45-9f12-2372feb540ff" providerId="ADAL" clId="{B29CEFCF-24BC-4847-988F-086BAE21519A}" dt="2021-06-15T10:50:31.670" v="147" actId="478"/>
          <ac:spMkLst>
            <pc:docMk/>
            <pc:sldMk cId="3087812012" sldId="259"/>
            <ac:spMk id="19" creationId="{281CA423-EC11-4403-A8AD-512EAF873716}"/>
          </ac:spMkLst>
        </pc:spChg>
        <pc:spChg chg="del">
          <ac:chgData name="Marta Estrela" userId="7250bf76-ff25-4d45-9f12-2372feb540ff" providerId="ADAL" clId="{B29CEFCF-24BC-4847-988F-086BAE21519A}" dt="2021-06-15T10:45:41.966" v="89"/>
          <ac:spMkLst>
            <pc:docMk/>
            <pc:sldMk cId="3087812012" sldId="259"/>
            <ac:spMk id="20" creationId="{FA75DFED-A0C1-4A83-BE1D-0271C1826EF6}"/>
          </ac:spMkLst>
        </pc:spChg>
        <pc:spChg chg="del">
          <ac:chgData name="Marta Estrela" userId="7250bf76-ff25-4d45-9f12-2372feb540ff" providerId="ADAL" clId="{B29CEFCF-24BC-4847-988F-086BAE21519A}" dt="2021-06-15T10:50:27.794" v="146" actId="478"/>
          <ac:spMkLst>
            <pc:docMk/>
            <pc:sldMk cId="3087812012" sldId="259"/>
            <ac:spMk id="21" creationId="{50DBA0C7-8A25-4E59-AD95-D83B43922142}"/>
          </ac:spMkLst>
        </pc:spChg>
        <pc:spChg chg="mod">
          <ac:chgData name="Marta Estrela" userId="7250bf76-ff25-4d45-9f12-2372feb540ff" providerId="ADAL" clId="{B29CEFCF-24BC-4847-988F-086BAE21519A}" dt="2021-06-15T10:50:38.549" v="148" actId="164"/>
          <ac:spMkLst>
            <pc:docMk/>
            <pc:sldMk cId="3087812012" sldId="259"/>
            <ac:spMk id="23" creationId="{A4006BFC-BA99-4B99-B51F-401E511FEBF0}"/>
          </ac:spMkLst>
        </pc:spChg>
        <pc:spChg chg="del">
          <ac:chgData name="Marta Estrela" userId="7250bf76-ff25-4d45-9f12-2372feb540ff" providerId="ADAL" clId="{B29CEFCF-24BC-4847-988F-086BAE21519A}" dt="2021-06-15T10:50:27.794" v="146" actId="478"/>
          <ac:spMkLst>
            <pc:docMk/>
            <pc:sldMk cId="3087812012" sldId="259"/>
            <ac:spMk id="25" creationId="{C1D63995-87B0-4C65-B662-3AF8094CD227}"/>
          </ac:spMkLst>
        </pc:spChg>
        <pc:spChg chg="mod">
          <ac:chgData name="Marta Estrela" userId="7250bf76-ff25-4d45-9f12-2372feb540ff" providerId="ADAL" clId="{B29CEFCF-24BC-4847-988F-086BAE21519A}" dt="2021-06-15T10:50:38.549" v="148" actId="164"/>
          <ac:spMkLst>
            <pc:docMk/>
            <pc:sldMk cId="3087812012" sldId="259"/>
            <ac:spMk id="26" creationId="{DB305E81-15CD-4C76-A546-8E4A2211736A}"/>
          </ac:spMkLst>
        </pc:spChg>
        <pc:spChg chg="del">
          <ac:chgData name="Marta Estrela" userId="7250bf76-ff25-4d45-9f12-2372feb540ff" providerId="ADAL" clId="{B29CEFCF-24BC-4847-988F-086BAE21519A}" dt="2021-06-15T10:50:31.670" v="147" actId="478"/>
          <ac:spMkLst>
            <pc:docMk/>
            <pc:sldMk cId="3087812012" sldId="259"/>
            <ac:spMk id="28" creationId="{C8C0397E-32E4-4926-A96B-4437DF830B4C}"/>
          </ac:spMkLst>
        </pc:spChg>
        <pc:spChg chg="del">
          <ac:chgData name="Marta Estrela" userId="7250bf76-ff25-4d45-9f12-2372feb540ff" providerId="ADAL" clId="{B29CEFCF-24BC-4847-988F-086BAE21519A}" dt="2021-06-15T10:50:31.670" v="147" actId="478"/>
          <ac:spMkLst>
            <pc:docMk/>
            <pc:sldMk cId="3087812012" sldId="259"/>
            <ac:spMk id="29" creationId="{2946FA2D-AF4D-447E-9E9D-10C6033C9FCF}"/>
          </ac:spMkLst>
        </pc:spChg>
        <pc:spChg chg="del">
          <ac:chgData name="Marta Estrela" userId="7250bf76-ff25-4d45-9f12-2372feb540ff" providerId="ADAL" clId="{B29CEFCF-24BC-4847-988F-086BAE21519A}" dt="2021-06-15T10:50:31.670" v="147" actId="478"/>
          <ac:spMkLst>
            <pc:docMk/>
            <pc:sldMk cId="3087812012" sldId="259"/>
            <ac:spMk id="31" creationId="{A68B8221-B2D5-4540-9B3E-6FA0EB1E3903}"/>
          </ac:spMkLst>
        </pc:spChg>
        <pc:spChg chg="del">
          <ac:chgData name="Marta Estrela" userId="7250bf76-ff25-4d45-9f12-2372feb540ff" providerId="ADAL" clId="{B29CEFCF-24BC-4847-988F-086BAE21519A}" dt="2021-06-15T10:50:27.794" v="146" actId="478"/>
          <ac:spMkLst>
            <pc:docMk/>
            <pc:sldMk cId="3087812012" sldId="259"/>
            <ac:spMk id="32" creationId="{3A9BDAB2-AC9D-4232-AF0F-9292E7253A41}"/>
          </ac:spMkLst>
        </pc:spChg>
        <pc:spChg chg="del">
          <ac:chgData name="Marta Estrela" userId="7250bf76-ff25-4d45-9f12-2372feb540ff" providerId="ADAL" clId="{B29CEFCF-24BC-4847-988F-086BAE21519A}" dt="2021-06-15T10:50:27.794" v="146" actId="478"/>
          <ac:spMkLst>
            <pc:docMk/>
            <pc:sldMk cId="3087812012" sldId="259"/>
            <ac:spMk id="33" creationId="{83855EAA-7BC4-4AD2-A4E0-774E43AE4F2D}"/>
          </ac:spMkLst>
        </pc:spChg>
        <pc:spChg chg="del">
          <ac:chgData name="Marta Estrela" userId="7250bf76-ff25-4d45-9f12-2372feb540ff" providerId="ADAL" clId="{B29CEFCF-24BC-4847-988F-086BAE21519A}" dt="2021-06-15T10:50:27.794" v="146" actId="478"/>
          <ac:spMkLst>
            <pc:docMk/>
            <pc:sldMk cId="3087812012" sldId="259"/>
            <ac:spMk id="34" creationId="{9237CD84-D6A2-4C15-8E5D-39825C6AA6E4}"/>
          </ac:spMkLst>
        </pc:spChg>
        <pc:spChg chg="mod">
          <ac:chgData name="Marta Estrela" userId="7250bf76-ff25-4d45-9f12-2372feb540ff" providerId="ADAL" clId="{B29CEFCF-24BC-4847-988F-086BAE21519A}" dt="2021-06-15T10:50:38.549" v="148" actId="164"/>
          <ac:spMkLst>
            <pc:docMk/>
            <pc:sldMk cId="3087812012" sldId="259"/>
            <ac:spMk id="35" creationId="{C51DA028-FE4D-4AD5-9C86-A9E91FFE3914}"/>
          </ac:spMkLst>
        </pc:spChg>
        <pc:spChg chg="mod">
          <ac:chgData name="Marta Estrela" userId="7250bf76-ff25-4d45-9f12-2372feb540ff" providerId="ADAL" clId="{B29CEFCF-24BC-4847-988F-086BAE21519A}" dt="2021-06-15T10:50:38.549" v="148" actId="164"/>
          <ac:spMkLst>
            <pc:docMk/>
            <pc:sldMk cId="3087812012" sldId="259"/>
            <ac:spMk id="36" creationId="{688667CD-C7EF-42D1-99E7-B28605B17AAF}"/>
          </ac:spMkLst>
        </pc:spChg>
        <pc:spChg chg="mod">
          <ac:chgData name="Marta Estrela" userId="7250bf76-ff25-4d45-9f12-2372feb540ff" providerId="ADAL" clId="{B29CEFCF-24BC-4847-988F-086BAE21519A}" dt="2021-06-15T10:50:38.549" v="148" actId="164"/>
          <ac:spMkLst>
            <pc:docMk/>
            <pc:sldMk cId="3087812012" sldId="259"/>
            <ac:spMk id="37" creationId="{1857D528-0445-49D7-9846-BDD5EA174D7B}"/>
          </ac:spMkLst>
        </pc:spChg>
        <pc:spChg chg="add">
          <ac:chgData name="Marta Estrela" userId="7250bf76-ff25-4d45-9f12-2372feb540ff" providerId="ADAL" clId="{B29CEFCF-24BC-4847-988F-086BAE21519A}" dt="2021-06-15T10:50:44.034" v="149" actId="26606"/>
          <ac:spMkLst>
            <pc:docMk/>
            <pc:sldMk cId="3087812012" sldId="259"/>
            <ac:spMk id="42" creationId="{32BC26D8-82FB-445E-AA49-62A77D7C1EE0}"/>
          </ac:spMkLst>
        </pc:spChg>
        <pc:spChg chg="add">
          <ac:chgData name="Marta Estrela" userId="7250bf76-ff25-4d45-9f12-2372feb540ff" providerId="ADAL" clId="{B29CEFCF-24BC-4847-988F-086BAE21519A}" dt="2021-06-15T10:50:44.034" v="149" actId="26606"/>
          <ac:spMkLst>
            <pc:docMk/>
            <pc:sldMk cId="3087812012" sldId="259"/>
            <ac:spMk id="44" creationId="{CB44330D-EA18-4254-AA95-EB49948539B8}"/>
          </ac:spMkLst>
        </pc:spChg>
        <pc:grpChg chg="del">
          <ac:chgData name="Marta Estrela" userId="7250bf76-ff25-4d45-9f12-2372feb540ff" providerId="ADAL" clId="{B29CEFCF-24BC-4847-988F-086BAE21519A}" dt="2021-06-15T10:50:27.794" v="146" actId="478"/>
          <ac:grpSpMkLst>
            <pc:docMk/>
            <pc:sldMk cId="3087812012" sldId="259"/>
            <ac:grpSpMk id="2" creationId="{EB4BF057-EA90-448B-901C-05AE0C42A991}"/>
          </ac:grpSpMkLst>
        </pc:grpChg>
        <pc:grpChg chg="add mod">
          <ac:chgData name="Marta Estrela" userId="7250bf76-ff25-4d45-9f12-2372feb540ff" providerId="ADAL" clId="{B29CEFCF-24BC-4847-988F-086BAE21519A}" dt="2021-06-15T10:50:44.034" v="149" actId="26606"/>
          <ac:grpSpMkLst>
            <pc:docMk/>
            <pc:sldMk cId="3087812012" sldId="259"/>
            <ac:grpSpMk id="3" creationId="{57B2247B-F944-4C6E-A1BD-4A21742A99E2}"/>
          </ac:grpSpMkLst>
        </pc:grpChg>
        <pc:picChg chg="del">
          <ac:chgData name="Marta Estrela" userId="7250bf76-ff25-4d45-9f12-2372feb540ff" providerId="ADAL" clId="{B29CEFCF-24BC-4847-988F-086BAE21519A}" dt="2021-06-15T10:50:27.794" v="146" actId="478"/>
          <ac:picMkLst>
            <pc:docMk/>
            <pc:sldMk cId="3087812012" sldId="259"/>
            <ac:picMk id="6" creationId="{91CC455E-5E6A-4DE0-AE4C-1B03E81107AB}"/>
          </ac:picMkLst>
        </pc:picChg>
        <pc:picChg chg="del">
          <ac:chgData name="Marta Estrela" userId="7250bf76-ff25-4d45-9f12-2372feb540ff" providerId="ADAL" clId="{B29CEFCF-24BC-4847-988F-086BAE21519A}" dt="2021-06-15T10:50:31.670" v="147" actId="478"/>
          <ac:picMkLst>
            <pc:docMk/>
            <pc:sldMk cId="3087812012" sldId="259"/>
            <ac:picMk id="7" creationId="{4AF3076E-DD31-44BE-B219-2ECFA12D3B29}"/>
          </ac:picMkLst>
        </pc:picChg>
        <pc:picChg chg="mod">
          <ac:chgData name="Marta Estrela" userId="7250bf76-ff25-4d45-9f12-2372feb540ff" providerId="ADAL" clId="{B29CEFCF-24BC-4847-988F-086BAE21519A}" dt="2021-06-15T10:50:38.549" v="148" actId="164"/>
          <ac:picMkLst>
            <pc:docMk/>
            <pc:sldMk cId="3087812012" sldId="259"/>
            <ac:picMk id="10" creationId="{A471FFF3-F72E-493B-B40D-2ACAF4DEAF5D}"/>
          </ac:picMkLst>
        </pc:picChg>
        <pc:picChg chg="mod">
          <ac:chgData name="Marta Estrela" userId="7250bf76-ff25-4d45-9f12-2372feb540ff" providerId="ADAL" clId="{B29CEFCF-24BC-4847-988F-086BAE21519A}" dt="2021-06-15T10:50:38.549" v="148" actId="164"/>
          <ac:picMkLst>
            <pc:docMk/>
            <pc:sldMk cId="3087812012" sldId="259"/>
            <ac:picMk id="11" creationId="{4FEA127D-AC08-4787-A3A9-C3D52F56B7D6}"/>
          </ac:picMkLst>
        </pc:picChg>
      </pc:sldChg>
      <pc:sldChg chg="addSp modSp new mod setBg">
        <pc:chgData name="Marta Estrela" userId="7250bf76-ff25-4d45-9f12-2372feb540ff" providerId="ADAL" clId="{B29CEFCF-24BC-4847-988F-086BAE21519A}" dt="2021-06-23T13:50:08.684" v="164" actId="26606"/>
        <pc:sldMkLst>
          <pc:docMk/>
          <pc:sldMk cId="102567638" sldId="260"/>
        </pc:sldMkLst>
        <pc:spChg chg="add">
          <ac:chgData name="Marta Estrela" userId="7250bf76-ff25-4d45-9f12-2372feb540ff" providerId="ADAL" clId="{B29CEFCF-24BC-4847-988F-086BAE21519A}" dt="2021-06-23T13:50:08.684" v="164" actId="26606"/>
          <ac:spMkLst>
            <pc:docMk/>
            <pc:sldMk cId="102567638" sldId="260"/>
            <ac:spMk id="14" creationId="{4169DD87-3EBE-44CA-9654-8AE0466B2779}"/>
          </ac:spMkLst>
        </pc:spChg>
        <pc:picChg chg="add mod">
          <ac:chgData name="Marta Estrela" userId="7250bf76-ff25-4d45-9f12-2372feb540ff" providerId="ADAL" clId="{B29CEFCF-24BC-4847-988F-086BAE21519A}" dt="2021-06-23T13:50:08.684" v="164" actId="26606"/>
          <ac:picMkLst>
            <pc:docMk/>
            <pc:sldMk cId="102567638" sldId="260"/>
            <ac:picMk id="3" creationId="{76CBA9CC-35FC-49AC-8BA7-CBA3EC295E6F}"/>
          </ac:picMkLst>
        </pc:picChg>
        <pc:picChg chg="add mod ord">
          <ac:chgData name="Marta Estrela" userId="7250bf76-ff25-4d45-9f12-2372feb540ff" providerId="ADAL" clId="{B29CEFCF-24BC-4847-988F-086BAE21519A}" dt="2021-06-23T13:50:08.684" v="164" actId="26606"/>
          <ac:picMkLst>
            <pc:docMk/>
            <pc:sldMk cId="102567638" sldId="260"/>
            <ac:picMk id="5" creationId="{6E0975AD-2C61-4C72-B1FF-1C0E15BC8577}"/>
          </ac:picMkLst>
        </pc:picChg>
        <pc:picChg chg="add mod">
          <ac:chgData name="Marta Estrela" userId="7250bf76-ff25-4d45-9f12-2372feb540ff" providerId="ADAL" clId="{B29CEFCF-24BC-4847-988F-086BAE21519A}" dt="2021-06-23T13:50:08.684" v="164" actId="26606"/>
          <ac:picMkLst>
            <pc:docMk/>
            <pc:sldMk cId="102567638" sldId="260"/>
            <ac:picMk id="7" creationId="{25CA32E5-1520-4924-9E5C-653427AA2528}"/>
          </ac:picMkLst>
        </pc:picChg>
        <pc:picChg chg="add mod">
          <ac:chgData name="Marta Estrela" userId="7250bf76-ff25-4d45-9f12-2372feb540ff" providerId="ADAL" clId="{B29CEFCF-24BC-4847-988F-086BAE21519A}" dt="2021-06-23T13:50:08.684" v="164" actId="26606"/>
          <ac:picMkLst>
            <pc:docMk/>
            <pc:sldMk cId="102567638" sldId="260"/>
            <ac:picMk id="9" creationId="{316FD9D1-0E34-483C-819F-2CE6FFEA0EE4}"/>
          </ac:picMkLst>
        </pc:picChg>
      </pc:sldChg>
      <pc:sldMasterChg chg="modSp modSldLayout">
        <pc:chgData name="Marta Estrela" userId="7250bf76-ff25-4d45-9f12-2372feb540ff" providerId="ADAL" clId="{B29CEFCF-24BC-4847-988F-086BAE21519A}" dt="2021-06-02T10:48:36.455" v="15"/>
        <pc:sldMasterMkLst>
          <pc:docMk/>
          <pc:sldMasterMk cId="2919656278" sldId="2147483648"/>
        </pc:sldMasterMkLst>
        <pc:spChg chg="mod">
          <ac:chgData name="Marta Estrela" userId="7250bf76-ff25-4d45-9f12-2372feb540ff" providerId="ADAL" clId="{B29CEFCF-24BC-4847-988F-086BAE21519A}" dt="2021-06-02T10:48:36.455" v="15"/>
          <ac:spMkLst>
            <pc:docMk/>
            <pc:sldMasterMk cId="2919656278" sldId="2147483648"/>
            <ac:spMk id="2" creationId="{806C8826-0393-48F6-850C-7583431A2D20}"/>
          </ac:spMkLst>
        </pc:spChg>
        <pc:spChg chg="mod">
          <ac:chgData name="Marta Estrela" userId="7250bf76-ff25-4d45-9f12-2372feb540ff" providerId="ADAL" clId="{B29CEFCF-24BC-4847-988F-086BAE21519A}" dt="2021-06-02T10:48:36.455" v="15"/>
          <ac:spMkLst>
            <pc:docMk/>
            <pc:sldMasterMk cId="2919656278" sldId="2147483648"/>
            <ac:spMk id="3" creationId="{8BCC2082-2911-4B94-B1DE-0E8CD5FF4B63}"/>
          </ac:spMkLst>
        </pc:spChg>
        <pc:spChg chg="mod">
          <ac:chgData name="Marta Estrela" userId="7250bf76-ff25-4d45-9f12-2372feb540ff" providerId="ADAL" clId="{B29CEFCF-24BC-4847-988F-086BAE21519A}" dt="2021-06-02T10:48:36.455" v="15"/>
          <ac:spMkLst>
            <pc:docMk/>
            <pc:sldMasterMk cId="2919656278" sldId="2147483648"/>
            <ac:spMk id="4" creationId="{C5990F2F-A2F5-4C7B-AF7B-62A55662DB34}"/>
          </ac:spMkLst>
        </pc:spChg>
        <pc:spChg chg="mod">
          <ac:chgData name="Marta Estrela" userId="7250bf76-ff25-4d45-9f12-2372feb540ff" providerId="ADAL" clId="{B29CEFCF-24BC-4847-988F-086BAE21519A}" dt="2021-06-02T10:48:36.455" v="15"/>
          <ac:spMkLst>
            <pc:docMk/>
            <pc:sldMasterMk cId="2919656278" sldId="2147483648"/>
            <ac:spMk id="5" creationId="{9253D347-8858-4489-815B-4207E033D861}"/>
          </ac:spMkLst>
        </pc:spChg>
        <pc:spChg chg="mod">
          <ac:chgData name="Marta Estrela" userId="7250bf76-ff25-4d45-9f12-2372feb540ff" providerId="ADAL" clId="{B29CEFCF-24BC-4847-988F-086BAE21519A}" dt="2021-06-02T10:48:36.455" v="15"/>
          <ac:spMkLst>
            <pc:docMk/>
            <pc:sldMasterMk cId="2919656278" sldId="2147483648"/>
            <ac:spMk id="6" creationId="{441E20E8-E7C3-4F10-BE64-50EF99FE6C4D}"/>
          </ac:spMkLst>
        </pc:spChg>
        <pc:sldLayoutChg chg="modSp">
          <pc:chgData name="Marta Estrela" userId="7250bf76-ff25-4d45-9f12-2372feb540ff" providerId="ADAL" clId="{B29CEFCF-24BC-4847-988F-086BAE21519A}" dt="2021-06-02T10:48:36.455" v="15"/>
          <pc:sldLayoutMkLst>
            <pc:docMk/>
            <pc:sldMasterMk cId="2919656278" sldId="2147483648"/>
            <pc:sldLayoutMk cId="1395845836" sldId="2147483649"/>
          </pc:sldLayoutMkLst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1395845836" sldId="2147483649"/>
              <ac:spMk id="2" creationId="{D9DA0F15-9E06-4046-9CF7-4247D9D0492C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1395845836" sldId="2147483649"/>
              <ac:spMk id="3" creationId="{85827BDC-8336-47C9-9881-131C4CBC76C0}"/>
            </ac:spMkLst>
          </pc:spChg>
        </pc:sldLayoutChg>
        <pc:sldLayoutChg chg="modSp">
          <pc:chgData name="Marta Estrela" userId="7250bf76-ff25-4d45-9f12-2372feb540ff" providerId="ADAL" clId="{B29CEFCF-24BC-4847-988F-086BAE21519A}" dt="2021-06-02T10:48:36.455" v="15"/>
          <pc:sldLayoutMkLst>
            <pc:docMk/>
            <pc:sldMasterMk cId="2919656278" sldId="2147483648"/>
            <pc:sldLayoutMk cId="4055446138" sldId="2147483651"/>
          </pc:sldLayoutMkLst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55446138" sldId="2147483651"/>
              <ac:spMk id="2" creationId="{3965F150-A792-4CCC-9BAE-3EA7E22ABEE6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55446138" sldId="2147483651"/>
              <ac:spMk id="3" creationId="{1270E7A2-C780-4AE2-B37C-C131437F0754}"/>
            </ac:spMkLst>
          </pc:spChg>
        </pc:sldLayoutChg>
        <pc:sldLayoutChg chg="modSp">
          <pc:chgData name="Marta Estrela" userId="7250bf76-ff25-4d45-9f12-2372feb540ff" providerId="ADAL" clId="{B29CEFCF-24BC-4847-988F-086BAE21519A}" dt="2021-06-02T10:48:36.455" v="15"/>
          <pc:sldLayoutMkLst>
            <pc:docMk/>
            <pc:sldMasterMk cId="2919656278" sldId="2147483648"/>
            <pc:sldLayoutMk cId="1022374568" sldId="2147483652"/>
          </pc:sldLayoutMkLst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1022374568" sldId="2147483652"/>
              <ac:spMk id="3" creationId="{631326C4-89A3-470D-86DD-3FEA76FEF8DE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1022374568" sldId="2147483652"/>
              <ac:spMk id="4" creationId="{39D4DC1A-6804-4BE8-B96D-711A4017A915}"/>
            </ac:spMkLst>
          </pc:spChg>
        </pc:sldLayoutChg>
        <pc:sldLayoutChg chg="modSp">
          <pc:chgData name="Marta Estrela" userId="7250bf76-ff25-4d45-9f12-2372feb540ff" providerId="ADAL" clId="{B29CEFCF-24BC-4847-988F-086BAE21519A}" dt="2021-06-02T10:48:36.455" v="15"/>
          <pc:sldLayoutMkLst>
            <pc:docMk/>
            <pc:sldMasterMk cId="2919656278" sldId="2147483648"/>
            <pc:sldLayoutMk cId="2626534573" sldId="2147483653"/>
          </pc:sldLayoutMkLst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2626534573" sldId="2147483653"/>
              <ac:spMk id="2" creationId="{CBFACCC7-EA4C-467A-882D-0614950310ED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2626534573" sldId="2147483653"/>
              <ac:spMk id="3" creationId="{406DD89F-FA87-4C3A-AEB0-A38ABC90A0D9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2626534573" sldId="2147483653"/>
              <ac:spMk id="4" creationId="{D50B887D-0AB5-4ADF-8B77-2468E3424719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2626534573" sldId="2147483653"/>
              <ac:spMk id="5" creationId="{6FCF1606-88D7-461F-AC9A-4F0EF8BB8ABC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2626534573" sldId="2147483653"/>
              <ac:spMk id="6" creationId="{F728AB9A-020E-4987-B581-717720B6E0B0}"/>
            </ac:spMkLst>
          </pc:spChg>
        </pc:sldLayoutChg>
        <pc:sldLayoutChg chg="modSp">
          <pc:chgData name="Marta Estrela" userId="7250bf76-ff25-4d45-9f12-2372feb540ff" providerId="ADAL" clId="{B29CEFCF-24BC-4847-988F-086BAE21519A}" dt="2021-06-02T10:48:36.455" v="15"/>
          <pc:sldLayoutMkLst>
            <pc:docMk/>
            <pc:sldMasterMk cId="2919656278" sldId="2147483648"/>
            <pc:sldLayoutMk cId="4076007259" sldId="2147483656"/>
          </pc:sldLayoutMkLst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76007259" sldId="2147483656"/>
              <ac:spMk id="2" creationId="{17FADF9C-8B74-4E21-BA72-07912E05FB26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76007259" sldId="2147483656"/>
              <ac:spMk id="3" creationId="{E0308AF8-F0A8-40F6-B84D-DBA5BDE5448C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76007259" sldId="2147483656"/>
              <ac:spMk id="4" creationId="{500CC4AF-5159-474F-9CD6-35C697694582}"/>
            </ac:spMkLst>
          </pc:spChg>
        </pc:sldLayoutChg>
        <pc:sldLayoutChg chg="modSp">
          <pc:chgData name="Marta Estrela" userId="7250bf76-ff25-4d45-9f12-2372feb540ff" providerId="ADAL" clId="{B29CEFCF-24BC-4847-988F-086BAE21519A}" dt="2021-06-02T10:48:36.455" v="15"/>
          <pc:sldLayoutMkLst>
            <pc:docMk/>
            <pc:sldMasterMk cId="2919656278" sldId="2147483648"/>
            <pc:sldLayoutMk cId="4024064963" sldId="2147483657"/>
          </pc:sldLayoutMkLst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24064963" sldId="2147483657"/>
              <ac:spMk id="2" creationId="{13D104F2-599B-4237-AC09-70143F586895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24064963" sldId="2147483657"/>
              <ac:spMk id="3" creationId="{00AFD30E-36AC-440A-AF66-2D8804D29EA3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4024064963" sldId="2147483657"/>
              <ac:spMk id="4" creationId="{252F4190-584F-4A7B-A4FF-F87678CBC9F2}"/>
            </ac:spMkLst>
          </pc:spChg>
        </pc:sldLayoutChg>
        <pc:sldLayoutChg chg="modSp">
          <pc:chgData name="Marta Estrela" userId="7250bf76-ff25-4d45-9f12-2372feb540ff" providerId="ADAL" clId="{B29CEFCF-24BC-4847-988F-086BAE21519A}" dt="2021-06-02T10:48:36.455" v="15"/>
          <pc:sldLayoutMkLst>
            <pc:docMk/>
            <pc:sldMasterMk cId="2919656278" sldId="2147483648"/>
            <pc:sldLayoutMk cId="2210839494" sldId="2147483659"/>
          </pc:sldLayoutMkLst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2210839494" sldId="2147483659"/>
              <ac:spMk id="2" creationId="{A3790FC3-21AF-4896-ADD9-CB55BB5CBFC5}"/>
            </ac:spMkLst>
          </pc:spChg>
          <pc:spChg chg="mod">
            <ac:chgData name="Marta Estrela" userId="7250bf76-ff25-4d45-9f12-2372feb540ff" providerId="ADAL" clId="{B29CEFCF-24BC-4847-988F-086BAE21519A}" dt="2021-06-02T10:48:36.455" v="15"/>
            <ac:spMkLst>
              <pc:docMk/>
              <pc:sldMasterMk cId="2919656278" sldId="2147483648"/>
              <pc:sldLayoutMk cId="2210839494" sldId="2147483659"/>
              <ac:spMk id="3" creationId="{64D3A411-04A9-4C25-9F17-E69C88DE99E7}"/>
            </ac:spMkLst>
          </pc:spChg>
        </pc:sldLayoutChg>
      </pc:sldMasterChg>
    </pc:docChg>
  </pc:docChgLst>
  <pc:docChgLst>
    <pc:chgData name="Marta Estrela" userId="7250bf76-ff25-4d45-9f12-2372feb540ff" providerId="ADAL" clId="{EEE5B2BF-388B-469A-9BEE-C92C11703481}"/>
    <pc:docChg chg="undo custSel addSld delSld modSld">
      <pc:chgData name="Marta Estrela" userId="7250bf76-ff25-4d45-9f12-2372feb540ff" providerId="ADAL" clId="{EEE5B2BF-388B-469A-9BEE-C92C11703481}" dt="2021-08-20T21:07:20.251" v="803" actId="20577"/>
      <pc:docMkLst>
        <pc:docMk/>
      </pc:docMkLst>
      <pc:sldChg chg="addSp modSp mod">
        <pc:chgData name="Marta Estrela" userId="7250bf76-ff25-4d45-9f12-2372feb540ff" providerId="ADAL" clId="{EEE5B2BF-388B-469A-9BEE-C92C11703481}" dt="2021-08-20T21:02:17.023" v="196" actId="20577"/>
        <pc:sldMkLst>
          <pc:docMk/>
          <pc:sldMk cId="3639856774" sldId="256"/>
        </pc:sldMkLst>
        <pc:spChg chg="add mod">
          <ac:chgData name="Marta Estrela" userId="7250bf76-ff25-4d45-9f12-2372feb540ff" providerId="ADAL" clId="{EEE5B2BF-388B-469A-9BEE-C92C11703481}" dt="2021-08-20T21:02:17.023" v="196" actId="20577"/>
          <ac:spMkLst>
            <pc:docMk/>
            <pc:sldMk cId="3639856774" sldId="256"/>
            <ac:spMk id="9" creationId="{E83C8FB5-6CF3-41FA-8D5B-62BC5B10AB89}"/>
          </ac:spMkLst>
        </pc:spChg>
      </pc:sldChg>
      <pc:sldChg chg="addSp modSp mod">
        <pc:chgData name="Marta Estrela" userId="7250bf76-ff25-4d45-9f12-2372feb540ff" providerId="ADAL" clId="{EEE5B2BF-388B-469A-9BEE-C92C11703481}" dt="2021-08-20T21:03:11.183" v="298" actId="20577"/>
        <pc:sldMkLst>
          <pc:docMk/>
          <pc:sldMk cId="135140757" sldId="257"/>
        </pc:sldMkLst>
        <pc:spChg chg="add mod">
          <ac:chgData name="Marta Estrela" userId="7250bf76-ff25-4d45-9f12-2372feb540ff" providerId="ADAL" clId="{EEE5B2BF-388B-469A-9BEE-C92C11703481}" dt="2021-08-20T21:03:11.183" v="298" actId="20577"/>
          <ac:spMkLst>
            <pc:docMk/>
            <pc:sldMk cId="135140757" sldId="257"/>
            <ac:spMk id="10" creationId="{8538F659-FB5B-4DDB-BA4D-0DF7D7551277}"/>
          </ac:spMkLst>
        </pc:spChg>
      </pc:sldChg>
      <pc:sldChg chg="addSp modSp mod">
        <pc:chgData name="Marta Estrela" userId="7250bf76-ff25-4d45-9f12-2372feb540ff" providerId="ADAL" clId="{EEE5B2BF-388B-469A-9BEE-C92C11703481}" dt="2021-08-20T21:03:17.806" v="316" actId="20577"/>
        <pc:sldMkLst>
          <pc:docMk/>
          <pc:sldMk cId="2996517111" sldId="258"/>
        </pc:sldMkLst>
        <pc:spChg chg="add mod">
          <ac:chgData name="Marta Estrela" userId="7250bf76-ff25-4d45-9f12-2372feb540ff" providerId="ADAL" clId="{EEE5B2BF-388B-469A-9BEE-C92C11703481}" dt="2021-08-20T21:03:17.806" v="316" actId="20577"/>
          <ac:spMkLst>
            <pc:docMk/>
            <pc:sldMk cId="2996517111" sldId="258"/>
            <ac:spMk id="11" creationId="{A5622E0D-A060-4A8E-94FA-A4D39E599F3D}"/>
          </ac:spMkLst>
        </pc:spChg>
      </pc:sldChg>
      <pc:sldChg chg="addSp delSp modSp mod setBg">
        <pc:chgData name="Marta Estrela" userId="7250bf76-ff25-4d45-9f12-2372feb540ff" providerId="ADAL" clId="{EEE5B2BF-388B-469A-9BEE-C92C11703481}" dt="2021-08-20T21:04:25.772" v="469" actId="20577"/>
        <pc:sldMkLst>
          <pc:docMk/>
          <pc:sldMk cId="3087812012" sldId="259"/>
        </pc:sldMkLst>
        <pc:spChg chg="add mod">
          <ac:chgData name="Marta Estrela" userId="7250bf76-ff25-4d45-9f12-2372feb540ff" providerId="ADAL" clId="{EEE5B2BF-388B-469A-9BEE-C92C11703481}" dt="2021-08-20T21:04:25.772" v="469" actId="20577"/>
          <ac:spMkLst>
            <pc:docMk/>
            <pc:sldMk cId="3087812012" sldId="259"/>
            <ac:spMk id="18" creationId="{75E376B0-2A70-4A9E-A099-91C3BE873C7F}"/>
          </ac:spMkLst>
        </pc:spChg>
        <pc:spChg chg="del">
          <ac:chgData name="Marta Estrela" userId="7250bf76-ff25-4d45-9f12-2372feb540ff" providerId="ADAL" clId="{EEE5B2BF-388B-469A-9BEE-C92C11703481}" dt="2021-08-20T20:54:28.142" v="19" actId="26606"/>
          <ac:spMkLst>
            <pc:docMk/>
            <pc:sldMk cId="3087812012" sldId="259"/>
            <ac:spMk id="42" creationId="{32BC26D8-82FB-445E-AA49-62A77D7C1EE0}"/>
          </ac:spMkLst>
        </pc:spChg>
        <pc:spChg chg="del">
          <ac:chgData name="Marta Estrela" userId="7250bf76-ff25-4d45-9f12-2372feb540ff" providerId="ADAL" clId="{EEE5B2BF-388B-469A-9BEE-C92C11703481}" dt="2021-08-20T20:54:28.142" v="19" actId="26606"/>
          <ac:spMkLst>
            <pc:docMk/>
            <pc:sldMk cId="3087812012" sldId="259"/>
            <ac:spMk id="44" creationId="{CB44330D-EA18-4254-AA95-EB49948539B8}"/>
          </ac:spMkLst>
        </pc:spChg>
        <pc:spChg chg="add del">
          <ac:chgData name="Marta Estrela" userId="7250bf76-ff25-4d45-9f12-2372feb540ff" providerId="ADAL" clId="{EEE5B2BF-388B-469A-9BEE-C92C11703481}" dt="2021-08-20T20:54:43.662" v="22" actId="26606"/>
          <ac:spMkLst>
            <pc:docMk/>
            <pc:sldMk cId="3087812012" sldId="259"/>
            <ac:spMk id="49" creationId="{32BC26D8-82FB-445E-AA49-62A77D7C1EE0}"/>
          </ac:spMkLst>
        </pc:spChg>
        <pc:spChg chg="add del">
          <ac:chgData name="Marta Estrela" userId="7250bf76-ff25-4d45-9f12-2372feb540ff" providerId="ADAL" clId="{EEE5B2BF-388B-469A-9BEE-C92C11703481}" dt="2021-08-20T20:54:43.662" v="22" actId="26606"/>
          <ac:spMkLst>
            <pc:docMk/>
            <pc:sldMk cId="3087812012" sldId="259"/>
            <ac:spMk id="51" creationId="{CB44330D-EA18-4254-AA95-EB49948539B8}"/>
          </ac:spMkLst>
        </pc:spChg>
        <pc:spChg chg="add del">
          <ac:chgData name="Marta Estrela" userId="7250bf76-ff25-4d45-9f12-2372feb540ff" providerId="ADAL" clId="{EEE5B2BF-388B-469A-9BEE-C92C11703481}" dt="2021-08-20T20:54:43.662" v="22" actId="26606"/>
          <ac:spMkLst>
            <pc:docMk/>
            <pc:sldMk cId="3087812012" sldId="259"/>
            <ac:spMk id="56" creationId="{AB8C311F-7253-4AED-9701-7FC0708C41C7}"/>
          </ac:spMkLst>
        </pc:spChg>
        <pc:spChg chg="add del">
          <ac:chgData name="Marta Estrela" userId="7250bf76-ff25-4d45-9f12-2372feb540ff" providerId="ADAL" clId="{EEE5B2BF-388B-469A-9BEE-C92C11703481}" dt="2021-08-20T20:54:43.662" v="22" actId="26606"/>
          <ac:spMkLst>
            <pc:docMk/>
            <pc:sldMk cId="3087812012" sldId="259"/>
            <ac:spMk id="58" creationId="{E2384209-CB15-4CDF-9D31-C44FD9A3F20D}"/>
          </ac:spMkLst>
        </pc:spChg>
        <pc:spChg chg="add del">
          <ac:chgData name="Marta Estrela" userId="7250bf76-ff25-4d45-9f12-2372feb540ff" providerId="ADAL" clId="{EEE5B2BF-388B-469A-9BEE-C92C11703481}" dt="2021-08-20T20:54:43.662" v="22" actId="26606"/>
          <ac:spMkLst>
            <pc:docMk/>
            <pc:sldMk cId="3087812012" sldId="259"/>
            <ac:spMk id="60" creationId="{2633B3B5-CC90-43F0-8714-D31D1F3F0209}"/>
          </ac:spMkLst>
        </pc:spChg>
        <pc:spChg chg="add del">
          <ac:chgData name="Marta Estrela" userId="7250bf76-ff25-4d45-9f12-2372feb540ff" providerId="ADAL" clId="{EEE5B2BF-388B-469A-9BEE-C92C11703481}" dt="2021-08-20T20:54:43.662" v="22" actId="26606"/>
          <ac:spMkLst>
            <pc:docMk/>
            <pc:sldMk cId="3087812012" sldId="259"/>
            <ac:spMk id="62" creationId="{A8D57A06-A426-446D-B02C-A2DC6B62E45E}"/>
          </ac:spMkLst>
        </pc:spChg>
        <pc:grpChg chg="add mod">
          <ac:chgData name="Marta Estrela" userId="7250bf76-ff25-4d45-9f12-2372feb540ff" providerId="ADAL" clId="{EEE5B2BF-388B-469A-9BEE-C92C11703481}" dt="2021-08-20T20:54:43.662" v="22" actId="26606"/>
          <ac:grpSpMkLst>
            <pc:docMk/>
            <pc:sldMk cId="3087812012" sldId="259"/>
            <ac:grpSpMk id="3" creationId="{57B2247B-F944-4C6E-A1BD-4A21742A99E2}"/>
          </ac:grpSpMkLst>
        </pc:grpChg>
      </pc:sldChg>
      <pc:sldChg chg="addSp delSp modSp del mod">
        <pc:chgData name="Marta Estrela" userId="7250bf76-ff25-4d45-9f12-2372feb540ff" providerId="ADAL" clId="{EEE5B2BF-388B-469A-9BEE-C92C11703481}" dt="2021-08-20T20:57:22.692" v="63" actId="47"/>
        <pc:sldMkLst>
          <pc:docMk/>
          <pc:sldMk cId="102567638" sldId="260"/>
        </pc:sldMkLst>
        <pc:spChg chg="add del">
          <ac:chgData name="Marta Estrela" userId="7250bf76-ff25-4d45-9f12-2372feb540ff" providerId="ADAL" clId="{EEE5B2BF-388B-469A-9BEE-C92C11703481}" dt="2021-08-20T20:54:20.330" v="18" actId="26606"/>
          <ac:spMkLst>
            <pc:docMk/>
            <pc:sldMk cId="102567638" sldId="260"/>
            <ac:spMk id="14" creationId="{4169DD87-3EBE-44CA-9654-8AE0466B2779}"/>
          </ac:spMkLst>
        </pc:spChg>
        <pc:spChg chg="add del">
          <ac:chgData name="Marta Estrela" userId="7250bf76-ff25-4d45-9f12-2372feb540ff" providerId="ADAL" clId="{EEE5B2BF-388B-469A-9BEE-C92C11703481}" dt="2021-08-20T20:54:16.367" v="13" actId="26606"/>
          <ac:spMkLst>
            <pc:docMk/>
            <pc:sldMk cId="102567638" sldId="260"/>
            <ac:spMk id="19" creationId="{42A4FC2C-047E-45A5-965D-8E1E3BF09BC6}"/>
          </ac:spMkLst>
        </pc:spChg>
        <pc:spChg chg="add del">
          <ac:chgData name="Marta Estrela" userId="7250bf76-ff25-4d45-9f12-2372feb540ff" providerId="ADAL" clId="{EEE5B2BF-388B-469A-9BEE-C92C11703481}" dt="2021-08-20T20:54:18.523" v="15" actId="26606"/>
          <ac:spMkLst>
            <pc:docMk/>
            <pc:sldMk cId="102567638" sldId="260"/>
            <ac:spMk id="21" creationId="{A7B21A54-9BA3-4EA9-B460-5A829ADD9051}"/>
          </ac:spMkLst>
        </pc:spChg>
        <pc:spChg chg="add del">
          <ac:chgData name="Marta Estrela" userId="7250bf76-ff25-4d45-9f12-2372feb540ff" providerId="ADAL" clId="{EEE5B2BF-388B-469A-9BEE-C92C11703481}" dt="2021-08-20T20:54:18.523" v="15" actId="26606"/>
          <ac:spMkLst>
            <pc:docMk/>
            <pc:sldMk cId="102567638" sldId="260"/>
            <ac:spMk id="22" creationId="{B9FF99BD-075F-4761-A995-6FC574BD25EA}"/>
          </ac:spMkLst>
        </pc:spChg>
        <pc:spChg chg="add del">
          <ac:chgData name="Marta Estrela" userId="7250bf76-ff25-4d45-9f12-2372feb540ff" providerId="ADAL" clId="{EEE5B2BF-388B-469A-9BEE-C92C11703481}" dt="2021-08-20T20:54:18.523" v="15" actId="26606"/>
          <ac:spMkLst>
            <pc:docMk/>
            <pc:sldMk cId="102567638" sldId="260"/>
            <ac:spMk id="23" creationId="{6FA8F714-B9D8-488A-8CCA-E9948FF913A9}"/>
          </ac:spMkLst>
        </pc:spChg>
        <pc:spChg chg="add del">
          <ac:chgData name="Marta Estrela" userId="7250bf76-ff25-4d45-9f12-2372feb540ff" providerId="ADAL" clId="{EEE5B2BF-388B-469A-9BEE-C92C11703481}" dt="2021-08-20T20:54:20.324" v="17" actId="26606"/>
          <ac:spMkLst>
            <pc:docMk/>
            <pc:sldMk cId="102567638" sldId="260"/>
            <ac:spMk id="25" creationId="{42A4FC2C-047E-45A5-965D-8E1E3BF09BC6}"/>
          </ac:spMkLst>
        </pc:spChg>
        <pc:spChg chg="add">
          <ac:chgData name="Marta Estrela" userId="7250bf76-ff25-4d45-9f12-2372feb540ff" providerId="ADAL" clId="{EEE5B2BF-388B-469A-9BEE-C92C11703481}" dt="2021-08-20T20:54:20.330" v="18" actId="26606"/>
          <ac:spMkLst>
            <pc:docMk/>
            <pc:sldMk cId="102567638" sldId="260"/>
            <ac:spMk id="27" creationId="{32BC26D8-82FB-445E-AA49-62A77D7C1EE0}"/>
          </ac:spMkLst>
        </pc:spChg>
        <pc:spChg chg="add">
          <ac:chgData name="Marta Estrela" userId="7250bf76-ff25-4d45-9f12-2372feb540ff" providerId="ADAL" clId="{EEE5B2BF-388B-469A-9BEE-C92C11703481}" dt="2021-08-20T20:54:20.330" v="18" actId="26606"/>
          <ac:spMkLst>
            <pc:docMk/>
            <pc:sldMk cId="102567638" sldId="260"/>
            <ac:spMk id="28" creationId="{CB44330D-EA18-4254-AA95-EB49948539B8}"/>
          </ac:spMkLst>
        </pc:spChg>
        <pc:picChg chg="mod">
          <ac:chgData name="Marta Estrela" userId="7250bf76-ff25-4d45-9f12-2372feb540ff" providerId="ADAL" clId="{EEE5B2BF-388B-469A-9BEE-C92C11703481}" dt="2021-08-20T20:54:20.330" v="18" actId="26606"/>
          <ac:picMkLst>
            <pc:docMk/>
            <pc:sldMk cId="102567638" sldId="260"/>
            <ac:picMk id="3" creationId="{76CBA9CC-35FC-49AC-8BA7-CBA3EC295E6F}"/>
          </ac:picMkLst>
        </pc:picChg>
        <pc:picChg chg="del">
          <ac:chgData name="Marta Estrela" userId="7250bf76-ff25-4d45-9f12-2372feb540ff" providerId="ADAL" clId="{EEE5B2BF-388B-469A-9BEE-C92C11703481}" dt="2021-08-20T20:53:23.243" v="7" actId="478"/>
          <ac:picMkLst>
            <pc:docMk/>
            <pc:sldMk cId="102567638" sldId="260"/>
            <ac:picMk id="5" creationId="{6E0975AD-2C61-4C72-B1FF-1C0E15BC8577}"/>
          </ac:picMkLst>
        </pc:picChg>
        <pc:picChg chg="del">
          <ac:chgData name="Marta Estrela" userId="7250bf76-ff25-4d45-9f12-2372feb540ff" providerId="ADAL" clId="{EEE5B2BF-388B-469A-9BEE-C92C11703481}" dt="2021-08-20T20:53:21.781" v="6" actId="478"/>
          <ac:picMkLst>
            <pc:docMk/>
            <pc:sldMk cId="102567638" sldId="260"/>
            <ac:picMk id="7" creationId="{25CA32E5-1520-4924-9E5C-653427AA2528}"/>
          </ac:picMkLst>
        </pc:picChg>
        <pc:picChg chg="del">
          <ac:chgData name="Marta Estrela" userId="7250bf76-ff25-4d45-9f12-2372feb540ff" providerId="ADAL" clId="{EEE5B2BF-388B-469A-9BEE-C92C11703481}" dt="2021-08-20T20:53:23.941" v="8" actId="478"/>
          <ac:picMkLst>
            <pc:docMk/>
            <pc:sldMk cId="102567638" sldId="260"/>
            <ac:picMk id="9" creationId="{316FD9D1-0E34-483C-819F-2CE6FFEA0EE4}"/>
          </ac:picMkLst>
        </pc:picChg>
      </pc:sldChg>
      <pc:sldChg chg="addSp delSp modSp add del mod setBg delDesignElem">
        <pc:chgData name="Marta Estrela" userId="7250bf76-ff25-4d45-9f12-2372feb540ff" providerId="ADAL" clId="{EEE5B2BF-388B-469A-9BEE-C92C11703481}" dt="2021-08-20T20:58:30.342" v="85" actId="47"/>
        <pc:sldMkLst>
          <pc:docMk/>
          <pc:sldMk cId="1895378001" sldId="261"/>
        </pc:sldMkLst>
        <pc:spChg chg="add">
          <ac:chgData name="Marta Estrela" userId="7250bf76-ff25-4d45-9f12-2372feb540ff" providerId="ADAL" clId="{EEE5B2BF-388B-469A-9BEE-C92C11703481}" dt="2021-08-20T20:56:41.703" v="47" actId="26606"/>
          <ac:spMkLst>
            <pc:docMk/>
            <pc:sldMk cId="1895378001" sldId="261"/>
            <ac:spMk id="10" creationId="{CB44330D-EA18-4254-AA95-EB49948539B8}"/>
          </ac:spMkLst>
        </pc:spChg>
        <pc:spChg chg="add">
          <ac:chgData name="Marta Estrela" userId="7250bf76-ff25-4d45-9f12-2372feb540ff" providerId="ADAL" clId="{EEE5B2BF-388B-469A-9BEE-C92C11703481}" dt="2021-08-20T20:56:41.703" v="47" actId="26606"/>
          <ac:spMkLst>
            <pc:docMk/>
            <pc:sldMk cId="1895378001" sldId="261"/>
            <ac:spMk id="12" creationId="{32BC26D8-82FB-445E-AA49-62A77D7C1EE0}"/>
          </ac:spMkLst>
        </pc:spChg>
        <pc:spChg chg="del">
          <ac:chgData name="Marta Estrela" userId="7250bf76-ff25-4d45-9f12-2372feb540ff" providerId="ADAL" clId="{EEE5B2BF-388B-469A-9BEE-C92C11703481}" dt="2021-08-20T20:53:16.232" v="1"/>
          <ac:spMkLst>
            <pc:docMk/>
            <pc:sldMk cId="1895378001" sldId="261"/>
            <ac:spMk id="14" creationId="{4169DD87-3EBE-44CA-9654-8AE0466B2779}"/>
          </ac:spMkLst>
        </pc:spChg>
        <pc:picChg chg="del">
          <ac:chgData name="Marta Estrela" userId="7250bf76-ff25-4d45-9f12-2372feb540ff" providerId="ADAL" clId="{EEE5B2BF-388B-469A-9BEE-C92C11703481}" dt="2021-08-20T20:53:29" v="9" actId="478"/>
          <ac:picMkLst>
            <pc:docMk/>
            <pc:sldMk cId="1895378001" sldId="261"/>
            <ac:picMk id="3" creationId="{76CBA9CC-35FC-49AC-8BA7-CBA3EC295E6F}"/>
          </ac:picMkLst>
        </pc:picChg>
        <pc:picChg chg="del">
          <ac:chgData name="Marta Estrela" userId="7250bf76-ff25-4d45-9f12-2372feb540ff" providerId="ADAL" clId="{EEE5B2BF-388B-469A-9BEE-C92C11703481}" dt="2021-08-20T20:53:29" v="9" actId="478"/>
          <ac:picMkLst>
            <pc:docMk/>
            <pc:sldMk cId="1895378001" sldId="261"/>
            <ac:picMk id="5" creationId="{6E0975AD-2C61-4C72-B1FF-1C0E15BC8577}"/>
          </ac:picMkLst>
        </pc:picChg>
        <pc:picChg chg="mod">
          <ac:chgData name="Marta Estrela" userId="7250bf76-ff25-4d45-9f12-2372feb540ff" providerId="ADAL" clId="{EEE5B2BF-388B-469A-9BEE-C92C11703481}" dt="2021-08-20T20:56:41.703" v="47" actId="26606"/>
          <ac:picMkLst>
            <pc:docMk/>
            <pc:sldMk cId="1895378001" sldId="261"/>
            <ac:picMk id="7" creationId="{25CA32E5-1520-4924-9E5C-653427AA2528}"/>
          </ac:picMkLst>
        </pc:picChg>
        <pc:picChg chg="del">
          <ac:chgData name="Marta Estrela" userId="7250bf76-ff25-4d45-9f12-2372feb540ff" providerId="ADAL" clId="{EEE5B2BF-388B-469A-9BEE-C92C11703481}" dt="2021-08-20T20:53:29" v="9" actId="478"/>
          <ac:picMkLst>
            <pc:docMk/>
            <pc:sldMk cId="1895378001" sldId="261"/>
            <ac:picMk id="9" creationId="{316FD9D1-0E34-483C-819F-2CE6FFEA0EE4}"/>
          </ac:picMkLst>
        </pc:picChg>
      </pc:sldChg>
      <pc:sldChg chg="addSp delSp modSp add del mod setBg delDesignElem">
        <pc:chgData name="Marta Estrela" userId="7250bf76-ff25-4d45-9f12-2372feb540ff" providerId="ADAL" clId="{EEE5B2BF-388B-469A-9BEE-C92C11703481}" dt="2021-08-20T20:58:30.342" v="85" actId="47"/>
        <pc:sldMkLst>
          <pc:docMk/>
          <pc:sldMk cId="3931402963" sldId="262"/>
        </pc:sldMkLst>
        <pc:spChg chg="add">
          <ac:chgData name="Marta Estrela" userId="7250bf76-ff25-4d45-9f12-2372feb540ff" providerId="ADAL" clId="{EEE5B2BF-388B-469A-9BEE-C92C11703481}" dt="2021-08-20T20:56:46.002" v="48" actId="26606"/>
          <ac:spMkLst>
            <pc:docMk/>
            <pc:sldMk cId="3931402963" sldId="262"/>
            <ac:spMk id="10" creationId="{32BC26D8-82FB-445E-AA49-62A77D7C1EE0}"/>
          </ac:spMkLst>
        </pc:spChg>
        <pc:spChg chg="add">
          <ac:chgData name="Marta Estrela" userId="7250bf76-ff25-4d45-9f12-2372feb540ff" providerId="ADAL" clId="{EEE5B2BF-388B-469A-9BEE-C92C11703481}" dt="2021-08-20T20:56:46.002" v="48" actId="26606"/>
          <ac:spMkLst>
            <pc:docMk/>
            <pc:sldMk cId="3931402963" sldId="262"/>
            <ac:spMk id="12" creationId="{CB44330D-EA18-4254-AA95-EB49948539B8}"/>
          </ac:spMkLst>
        </pc:spChg>
        <pc:spChg chg="del">
          <ac:chgData name="Marta Estrela" userId="7250bf76-ff25-4d45-9f12-2372feb540ff" providerId="ADAL" clId="{EEE5B2BF-388B-469A-9BEE-C92C11703481}" dt="2021-08-20T20:53:16.772" v="3"/>
          <ac:spMkLst>
            <pc:docMk/>
            <pc:sldMk cId="3931402963" sldId="262"/>
            <ac:spMk id="14" creationId="{4169DD87-3EBE-44CA-9654-8AE0466B2779}"/>
          </ac:spMkLst>
        </pc:spChg>
        <pc:picChg chg="del">
          <ac:chgData name="Marta Estrela" userId="7250bf76-ff25-4d45-9f12-2372feb540ff" providerId="ADAL" clId="{EEE5B2BF-388B-469A-9BEE-C92C11703481}" dt="2021-08-20T20:53:34.533" v="10" actId="478"/>
          <ac:picMkLst>
            <pc:docMk/>
            <pc:sldMk cId="3931402963" sldId="262"/>
            <ac:picMk id="3" creationId="{76CBA9CC-35FC-49AC-8BA7-CBA3EC295E6F}"/>
          </ac:picMkLst>
        </pc:picChg>
        <pc:picChg chg="mod">
          <ac:chgData name="Marta Estrela" userId="7250bf76-ff25-4d45-9f12-2372feb540ff" providerId="ADAL" clId="{EEE5B2BF-388B-469A-9BEE-C92C11703481}" dt="2021-08-20T20:56:46.002" v="48" actId="26606"/>
          <ac:picMkLst>
            <pc:docMk/>
            <pc:sldMk cId="3931402963" sldId="262"/>
            <ac:picMk id="5" creationId="{6E0975AD-2C61-4C72-B1FF-1C0E15BC8577}"/>
          </ac:picMkLst>
        </pc:picChg>
        <pc:picChg chg="del">
          <ac:chgData name="Marta Estrela" userId="7250bf76-ff25-4d45-9f12-2372feb540ff" providerId="ADAL" clId="{EEE5B2BF-388B-469A-9BEE-C92C11703481}" dt="2021-08-20T20:53:34.533" v="10" actId="478"/>
          <ac:picMkLst>
            <pc:docMk/>
            <pc:sldMk cId="3931402963" sldId="262"/>
            <ac:picMk id="7" creationId="{25CA32E5-1520-4924-9E5C-653427AA2528}"/>
          </ac:picMkLst>
        </pc:picChg>
        <pc:picChg chg="del">
          <ac:chgData name="Marta Estrela" userId="7250bf76-ff25-4d45-9f12-2372feb540ff" providerId="ADAL" clId="{EEE5B2BF-388B-469A-9BEE-C92C11703481}" dt="2021-08-20T20:53:34.533" v="10" actId="478"/>
          <ac:picMkLst>
            <pc:docMk/>
            <pc:sldMk cId="3931402963" sldId="262"/>
            <ac:picMk id="9" creationId="{316FD9D1-0E34-483C-819F-2CE6FFEA0EE4}"/>
          </ac:picMkLst>
        </pc:picChg>
      </pc:sldChg>
      <pc:sldChg chg="addSp delSp modSp add del mod setBg setClrOvrMap delDesignElem">
        <pc:chgData name="Marta Estrela" userId="7250bf76-ff25-4d45-9f12-2372feb540ff" providerId="ADAL" clId="{EEE5B2BF-388B-469A-9BEE-C92C11703481}" dt="2021-08-20T20:58:30.342" v="85" actId="47"/>
        <pc:sldMkLst>
          <pc:docMk/>
          <pc:sldMk cId="754721256" sldId="263"/>
        </pc:sldMkLst>
        <pc:spChg chg="add">
          <ac:chgData name="Marta Estrela" userId="7250bf76-ff25-4d45-9f12-2372feb540ff" providerId="ADAL" clId="{EEE5B2BF-388B-469A-9BEE-C92C11703481}" dt="2021-08-20T20:56:50.352" v="51" actId="26606"/>
          <ac:spMkLst>
            <pc:docMk/>
            <pc:sldMk cId="754721256" sldId="263"/>
            <ac:spMk id="11" creationId="{32BC26D8-82FB-445E-AA49-62A77D7C1EE0}"/>
          </ac:spMkLst>
        </pc:spChg>
        <pc:spChg chg="del">
          <ac:chgData name="Marta Estrela" userId="7250bf76-ff25-4d45-9f12-2372feb540ff" providerId="ADAL" clId="{EEE5B2BF-388B-469A-9BEE-C92C11703481}" dt="2021-08-20T20:53:17.392" v="5"/>
          <ac:spMkLst>
            <pc:docMk/>
            <pc:sldMk cId="754721256" sldId="263"/>
            <ac:spMk id="14" creationId="{4169DD87-3EBE-44CA-9654-8AE0466B2779}"/>
          </ac:spMkLst>
        </pc:spChg>
        <pc:spChg chg="add">
          <ac:chgData name="Marta Estrela" userId="7250bf76-ff25-4d45-9f12-2372feb540ff" providerId="ADAL" clId="{EEE5B2BF-388B-469A-9BEE-C92C11703481}" dt="2021-08-20T20:56:50.352" v="51" actId="26606"/>
          <ac:spMkLst>
            <pc:docMk/>
            <pc:sldMk cId="754721256" sldId="263"/>
            <ac:spMk id="16" creationId="{CB44330D-EA18-4254-AA95-EB49948539B8}"/>
          </ac:spMkLst>
        </pc:spChg>
        <pc:picChg chg="del">
          <ac:chgData name="Marta Estrela" userId="7250bf76-ff25-4d45-9f12-2372feb540ff" providerId="ADAL" clId="{EEE5B2BF-388B-469A-9BEE-C92C11703481}" dt="2021-08-20T20:53:40.625" v="11" actId="478"/>
          <ac:picMkLst>
            <pc:docMk/>
            <pc:sldMk cId="754721256" sldId="263"/>
            <ac:picMk id="3" creationId="{76CBA9CC-35FC-49AC-8BA7-CBA3EC295E6F}"/>
          </ac:picMkLst>
        </pc:picChg>
        <pc:picChg chg="del">
          <ac:chgData name="Marta Estrela" userId="7250bf76-ff25-4d45-9f12-2372feb540ff" providerId="ADAL" clId="{EEE5B2BF-388B-469A-9BEE-C92C11703481}" dt="2021-08-20T20:53:40.625" v="11" actId="478"/>
          <ac:picMkLst>
            <pc:docMk/>
            <pc:sldMk cId="754721256" sldId="263"/>
            <ac:picMk id="5" creationId="{6E0975AD-2C61-4C72-B1FF-1C0E15BC8577}"/>
          </ac:picMkLst>
        </pc:picChg>
        <pc:picChg chg="del">
          <ac:chgData name="Marta Estrela" userId="7250bf76-ff25-4d45-9f12-2372feb540ff" providerId="ADAL" clId="{EEE5B2BF-388B-469A-9BEE-C92C11703481}" dt="2021-08-20T20:53:40.625" v="11" actId="478"/>
          <ac:picMkLst>
            <pc:docMk/>
            <pc:sldMk cId="754721256" sldId="263"/>
            <ac:picMk id="7" creationId="{25CA32E5-1520-4924-9E5C-653427AA2528}"/>
          </ac:picMkLst>
        </pc:picChg>
        <pc:picChg chg="mod">
          <ac:chgData name="Marta Estrela" userId="7250bf76-ff25-4d45-9f12-2372feb540ff" providerId="ADAL" clId="{EEE5B2BF-388B-469A-9BEE-C92C11703481}" dt="2021-08-20T20:56:50.352" v="51" actId="26606"/>
          <ac:picMkLst>
            <pc:docMk/>
            <pc:sldMk cId="754721256" sldId="263"/>
            <ac:picMk id="9" creationId="{316FD9D1-0E34-483C-819F-2CE6FFEA0EE4}"/>
          </ac:picMkLst>
        </pc:picChg>
      </pc:sldChg>
      <pc:sldChg chg="addSp delSp modSp add mod">
        <pc:chgData name="Marta Estrela" userId="7250bf76-ff25-4d45-9f12-2372feb540ff" providerId="ADAL" clId="{EEE5B2BF-388B-469A-9BEE-C92C11703481}" dt="2021-08-20T21:05:15.683" v="567" actId="20577"/>
        <pc:sldMkLst>
          <pc:docMk/>
          <pc:sldMk cId="2805510449" sldId="264"/>
        </pc:sldMkLst>
        <pc:spChg chg="add mod">
          <ac:chgData name="Marta Estrela" userId="7250bf76-ff25-4d45-9f12-2372feb540ff" providerId="ADAL" clId="{EEE5B2BF-388B-469A-9BEE-C92C11703481}" dt="2021-08-20T21:05:15.683" v="567" actId="20577"/>
          <ac:spMkLst>
            <pc:docMk/>
            <pc:sldMk cId="2805510449" sldId="264"/>
            <ac:spMk id="13" creationId="{9C589F11-A7D4-4E22-89C5-D6303A325265}"/>
          </ac:spMkLst>
        </pc:spChg>
        <pc:spChg chg="mod ord topLvl">
          <ac:chgData name="Marta Estrela" userId="7250bf76-ff25-4d45-9f12-2372feb540ff" providerId="ADAL" clId="{EEE5B2BF-388B-469A-9BEE-C92C11703481}" dt="2021-08-20T20:57:13.043" v="61" actId="20577"/>
          <ac:spMkLst>
            <pc:docMk/>
            <pc:sldMk cId="2805510449" sldId="264"/>
            <ac:spMk id="23" creationId="{A4006BFC-BA99-4B99-B51F-401E511FEBF0}"/>
          </ac:spMkLst>
        </pc:spChg>
        <pc:spChg chg="mod ord topLvl">
          <ac:chgData name="Marta Estrela" userId="7250bf76-ff25-4d45-9f12-2372feb540ff" providerId="ADAL" clId="{EEE5B2BF-388B-469A-9BEE-C92C11703481}" dt="2021-08-20T20:55:55.303" v="36" actId="166"/>
          <ac:spMkLst>
            <pc:docMk/>
            <pc:sldMk cId="2805510449" sldId="264"/>
            <ac:spMk id="26" creationId="{DB305E81-15CD-4C76-A546-8E4A2211736A}"/>
          </ac:spMkLst>
        </pc:spChg>
        <pc:spChg chg="mod ord topLvl">
          <ac:chgData name="Marta Estrela" userId="7250bf76-ff25-4d45-9f12-2372feb540ff" providerId="ADAL" clId="{EEE5B2BF-388B-469A-9BEE-C92C11703481}" dt="2021-08-20T20:56:18.813" v="42" actId="1076"/>
          <ac:spMkLst>
            <pc:docMk/>
            <pc:sldMk cId="2805510449" sldId="264"/>
            <ac:spMk id="35" creationId="{C51DA028-FE4D-4AD5-9C86-A9E91FFE3914}"/>
          </ac:spMkLst>
        </pc:spChg>
        <pc:spChg chg="del mod ord topLvl">
          <ac:chgData name="Marta Estrela" userId="7250bf76-ff25-4d45-9f12-2372feb540ff" providerId="ADAL" clId="{EEE5B2BF-388B-469A-9BEE-C92C11703481}" dt="2021-08-20T20:56:07.562" v="39" actId="478"/>
          <ac:spMkLst>
            <pc:docMk/>
            <pc:sldMk cId="2805510449" sldId="264"/>
            <ac:spMk id="36" creationId="{688667CD-C7EF-42D1-99E7-B28605B17AAF}"/>
          </ac:spMkLst>
        </pc:spChg>
        <pc:spChg chg="mod ord topLvl">
          <ac:chgData name="Marta Estrela" userId="7250bf76-ff25-4d45-9f12-2372feb540ff" providerId="ADAL" clId="{EEE5B2BF-388B-469A-9BEE-C92C11703481}" dt="2021-08-20T20:56:29.083" v="45" actId="1076"/>
          <ac:spMkLst>
            <pc:docMk/>
            <pc:sldMk cId="2805510449" sldId="264"/>
            <ac:spMk id="37" creationId="{1857D528-0445-49D7-9846-BDD5EA174D7B}"/>
          </ac:spMkLst>
        </pc:spChg>
        <pc:grpChg chg="add del">
          <ac:chgData name="Marta Estrela" userId="7250bf76-ff25-4d45-9f12-2372feb540ff" providerId="ADAL" clId="{EEE5B2BF-388B-469A-9BEE-C92C11703481}" dt="2021-08-20T20:55:15.342" v="29" actId="165"/>
          <ac:grpSpMkLst>
            <pc:docMk/>
            <pc:sldMk cId="2805510449" sldId="264"/>
            <ac:grpSpMk id="3" creationId="{57B2247B-F944-4C6E-A1BD-4A21742A99E2}"/>
          </ac:grpSpMkLst>
        </pc:grpChg>
        <pc:picChg chg="del mod topLvl">
          <ac:chgData name="Marta Estrela" userId="7250bf76-ff25-4d45-9f12-2372feb540ff" providerId="ADAL" clId="{EEE5B2BF-388B-469A-9BEE-C92C11703481}" dt="2021-08-20T20:55:18.483" v="30" actId="478"/>
          <ac:picMkLst>
            <pc:docMk/>
            <pc:sldMk cId="2805510449" sldId="264"/>
            <ac:picMk id="10" creationId="{A471FFF3-F72E-493B-B40D-2ACAF4DEAF5D}"/>
          </ac:picMkLst>
        </pc:picChg>
        <pc:picChg chg="del mod topLvl">
          <ac:chgData name="Marta Estrela" userId="7250bf76-ff25-4d45-9f12-2372feb540ff" providerId="ADAL" clId="{EEE5B2BF-388B-469A-9BEE-C92C11703481}" dt="2021-08-20T20:55:19.803" v="31" actId="478"/>
          <ac:picMkLst>
            <pc:docMk/>
            <pc:sldMk cId="2805510449" sldId="264"/>
            <ac:picMk id="11" creationId="{4FEA127D-AC08-4787-A3A9-C3D52F56B7D6}"/>
          </ac:picMkLst>
        </pc:picChg>
        <pc:picChg chg="add mod ord modCrop">
          <ac:chgData name="Marta Estrela" userId="7250bf76-ff25-4d45-9f12-2372feb540ff" providerId="ADAL" clId="{EEE5B2BF-388B-469A-9BEE-C92C11703481}" dt="2021-08-20T21:00:33.023" v="123" actId="732"/>
          <ac:picMkLst>
            <pc:docMk/>
            <pc:sldMk cId="2805510449" sldId="264"/>
            <ac:picMk id="12" creationId="{355E00D1-4653-4907-B36C-C4F0F028DA2F}"/>
          </ac:picMkLst>
        </pc:picChg>
      </pc:sldChg>
      <pc:sldChg chg="addSp delSp modSp add mod">
        <pc:chgData name="Marta Estrela" userId="7250bf76-ff25-4d45-9f12-2372feb540ff" providerId="ADAL" clId="{EEE5B2BF-388B-469A-9BEE-C92C11703481}" dt="2021-08-20T21:06:02.802" v="656" actId="20577"/>
        <pc:sldMkLst>
          <pc:docMk/>
          <pc:sldMk cId="1307283709" sldId="265"/>
        </pc:sldMkLst>
        <pc:spChg chg="add mod">
          <ac:chgData name="Marta Estrela" userId="7250bf76-ff25-4d45-9f12-2372feb540ff" providerId="ADAL" clId="{EEE5B2BF-388B-469A-9BEE-C92C11703481}" dt="2021-08-20T21:06:02.802" v="656" actId="20577"/>
          <ac:spMkLst>
            <pc:docMk/>
            <pc:sldMk cId="1307283709" sldId="265"/>
            <ac:spMk id="10" creationId="{18E5A999-ECFD-420B-896C-987FF39B5820}"/>
          </ac:spMkLst>
        </pc:spChg>
        <pc:spChg chg="mod">
          <ac:chgData name="Marta Estrela" userId="7250bf76-ff25-4d45-9f12-2372feb540ff" providerId="ADAL" clId="{EEE5B2BF-388B-469A-9BEE-C92C11703481}" dt="2021-08-20T20:59:48.152" v="112" actId="20577"/>
          <ac:spMkLst>
            <pc:docMk/>
            <pc:sldMk cId="1307283709" sldId="265"/>
            <ac:spMk id="23" creationId="{A4006BFC-BA99-4B99-B51F-401E511FEBF0}"/>
          </ac:spMkLst>
        </pc:spChg>
        <pc:spChg chg="mod">
          <ac:chgData name="Marta Estrela" userId="7250bf76-ff25-4d45-9f12-2372feb540ff" providerId="ADAL" clId="{EEE5B2BF-388B-469A-9BEE-C92C11703481}" dt="2021-08-20T20:58:40.432" v="88" actId="20577"/>
          <ac:spMkLst>
            <pc:docMk/>
            <pc:sldMk cId="1307283709" sldId="265"/>
            <ac:spMk id="35" creationId="{C51DA028-FE4D-4AD5-9C86-A9E91FFE3914}"/>
          </ac:spMkLst>
        </pc:spChg>
        <pc:spChg chg="mod">
          <ac:chgData name="Marta Estrela" userId="7250bf76-ff25-4d45-9f12-2372feb540ff" providerId="ADAL" clId="{EEE5B2BF-388B-469A-9BEE-C92C11703481}" dt="2021-08-20T20:58:42.603" v="90" actId="20577"/>
          <ac:spMkLst>
            <pc:docMk/>
            <pc:sldMk cId="1307283709" sldId="265"/>
            <ac:spMk id="37" creationId="{1857D528-0445-49D7-9846-BDD5EA174D7B}"/>
          </ac:spMkLst>
        </pc:spChg>
        <pc:picChg chg="add mod ord modCrop">
          <ac:chgData name="Marta Estrela" userId="7250bf76-ff25-4d45-9f12-2372feb540ff" providerId="ADAL" clId="{EEE5B2BF-388B-469A-9BEE-C92C11703481}" dt="2021-08-20T21:00:23.003" v="122" actId="1035"/>
          <ac:picMkLst>
            <pc:docMk/>
            <pc:sldMk cId="1307283709" sldId="265"/>
            <ac:picMk id="9" creationId="{87B56063-5ACD-4220-9E6E-E9EBAFA60F82}"/>
          </ac:picMkLst>
        </pc:picChg>
        <pc:picChg chg="del">
          <ac:chgData name="Marta Estrela" userId="7250bf76-ff25-4d45-9f12-2372feb540ff" providerId="ADAL" clId="{EEE5B2BF-388B-469A-9BEE-C92C11703481}" dt="2021-08-20T20:57:17.302" v="62" actId="478"/>
          <ac:picMkLst>
            <pc:docMk/>
            <pc:sldMk cId="1307283709" sldId="265"/>
            <ac:picMk id="12" creationId="{355E00D1-4653-4907-B36C-C4F0F028DA2F}"/>
          </ac:picMkLst>
        </pc:picChg>
      </pc:sldChg>
      <pc:sldChg chg="addSp delSp add del setBg delDesignElem">
        <pc:chgData name="Marta Estrela" userId="7250bf76-ff25-4d45-9f12-2372feb540ff" providerId="ADAL" clId="{EEE5B2BF-388B-469A-9BEE-C92C11703481}" dt="2021-08-20T20:56:58.473" v="57"/>
        <pc:sldMkLst>
          <pc:docMk/>
          <pc:sldMk cId="2731660085" sldId="266"/>
        </pc:sldMkLst>
        <pc:spChg chg="add del">
          <ac:chgData name="Marta Estrela" userId="7250bf76-ff25-4d45-9f12-2372feb540ff" providerId="ADAL" clId="{EEE5B2BF-388B-469A-9BEE-C92C11703481}" dt="2021-08-20T20:56:58.473" v="57"/>
          <ac:spMkLst>
            <pc:docMk/>
            <pc:sldMk cId="2731660085" sldId="266"/>
            <ac:spMk id="49" creationId="{32BC26D8-82FB-445E-AA49-62A77D7C1EE0}"/>
          </ac:spMkLst>
        </pc:spChg>
        <pc:spChg chg="add del">
          <ac:chgData name="Marta Estrela" userId="7250bf76-ff25-4d45-9f12-2372feb540ff" providerId="ADAL" clId="{EEE5B2BF-388B-469A-9BEE-C92C11703481}" dt="2021-08-20T20:56:58.473" v="57"/>
          <ac:spMkLst>
            <pc:docMk/>
            <pc:sldMk cId="2731660085" sldId="266"/>
            <ac:spMk id="51" creationId="{CB44330D-EA18-4254-AA95-EB49948539B8}"/>
          </ac:spMkLst>
        </pc:spChg>
      </pc:sldChg>
      <pc:sldChg chg="addSp delSp modSp add mod">
        <pc:chgData name="Marta Estrela" userId="7250bf76-ff25-4d45-9f12-2372feb540ff" providerId="ADAL" clId="{EEE5B2BF-388B-469A-9BEE-C92C11703481}" dt="2021-08-20T21:06:29.523" v="698" actId="20577"/>
        <pc:sldMkLst>
          <pc:docMk/>
          <pc:sldMk cId="2891686024" sldId="266"/>
        </pc:sldMkLst>
        <pc:spChg chg="add mod">
          <ac:chgData name="Marta Estrela" userId="7250bf76-ff25-4d45-9f12-2372feb540ff" providerId="ADAL" clId="{EEE5B2BF-388B-469A-9BEE-C92C11703481}" dt="2021-08-20T21:00:11.241" v="115" actId="2085"/>
          <ac:spMkLst>
            <pc:docMk/>
            <pc:sldMk cId="2891686024" sldId="266"/>
            <ac:spMk id="2" creationId="{23A62357-3E25-4E09-8D9D-EBC465EBF4A4}"/>
          </ac:spMkLst>
        </pc:spChg>
        <pc:spChg chg="add mod">
          <ac:chgData name="Marta Estrela" userId="7250bf76-ff25-4d45-9f12-2372feb540ff" providerId="ADAL" clId="{EEE5B2BF-388B-469A-9BEE-C92C11703481}" dt="2021-08-20T21:06:29.523" v="698" actId="20577"/>
          <ac:spMkLst>
            <pc:docMk/>
            <pc:sldMk cId="2891686024" sldId="266"/>
            <ac:spMk id="11" creationId="{3B999F02-136E-4F57-9568-2FE1652E4F92}"/>
          </ac:spMkLst>
        </pc:spChg>
        <pc:spChg chg="mod">
          <ac:chgData name="Marta Estrela" userId="7250bf76-ff25-4d45-9f12-2372feb540ff" providerId="ADAL" clId="{EEE5B2BF-388B-469A-9BEE-C92C11703481}" dt="2021-08-20T20:59:01.543" v="100" actId="20577"/>
          <ac:spMkLst>
            <pc:docMk/>
            <pc:sldMk cId="2891686024" sldId="266"/>
            <ac:spMk id="23" creationId="{A4006BFC-BA99-4B99-B51F-401E511FEBF0}"/>
          </ac:spMkLst>
        </pc:spChg>
        <pc:spChg chg="mod">
          <ac:chgData name="Marta Estrela" userId="7250bf76-ff25-4d45-9f12-2372feb540ff" providerId="ADAL" clId="{EEE5B2BF-388B-469A-9BEE-C92C11703481}" dt="2021-08-20T20:58:51.673" v="95" actId="1076"/>
          <ac:spMkLst>
            <pc:docMk/>
            <pc:sldMk cId="2891686024" sldId="266"/>
            <ac:spMk id="35" creationId="{C51DA028-FE4D-4AD5-9C86-A9E91FFE3914}"/>
          </ac:spMkLst>
        </pc:spChg>
        <pc:spChg chg="del">
          <ac:chgData name="Marta Estrela" userId="7250bf76-ff25-4d45-9f12-2372feb540ff" providerId="ADAL" clId="{EEE5B2BF-388B-469A-9BEE-C92C11703481}" dt="2021-08-20T20:58:55.062" v="96" actId="478"/>
          <ac:spMkLst>
            <pc:docMk/>
            <pc:sldMk cId="2891686024" sldId="266"/>
            <ac:spMk id="37" creationId="{1857D528-0445-49D7-9846-BDD5EA174D7B}"/>
          </ac:spMkLst>
        </pc:spChg>
        <pc:picChg chg="add mod ord">
          <ac:chgData name="Marta Estrela" userId="7250bf76-ff25-4d45-9f12-2372feb540ff" providerId="ADAL" clId="{EEE5B2BF-388B-469A-9BEE-C92C11703481}" dt="2021-08-20T20:58:09.986" v="78" actId="171"/>
          <ac:picMkLst>
            <pc:docMk/>
            <pc:sldMk cId="2891686024" sldId="266"/>
            <ac:picMk id="9" creationId="{4EE20DFD-A444-420D-983B-7C2155B76E5C}"/>
          </ac:picMkLst>
        </pc:picChg>
        <pc:picChg chg="del">
          <ac:chgData name="Marta Estrela" userId="7250bf76-ff25-4d45-9f12-2372feb540ff" providerId="ADAL" clId="{EEE5B2BF-388B-469A-9BEE-C92C11703481}" dt="2021-08-20T20:57:55.723" v="73" actId="478"/>
          <ac:picMkLst>
            <pc:docMk/>
            <pc:sldMk cId="2891686024" sldId="266"/>
            <ac:picMk id="12" creationId="{355E00D1-4653-4907-B36C-C4F0F028DA2F}"/>
          </ac:picMkLst>
        </pc:picChg>
      </pc:sldChg>
      <pc:sldChg chg="addSp delSp modSp add mod">
        <pc:chgData name="Marta Estrela" userId="7250bf76-ff25-4d45-9f12-2372feb540ff" providerId="ADAL" clId="{EEE5B2BF-388B-469A-9BEE-C92C11703481}" dt="2021-08-20T21:07:20.251" v="803" actId="20577"/>
        <pc:sldMkLst>
          <pc:docMk/>
          <pc:sldMk cId="164020171" sldId="267"/>
        </pc:sldMkLst>
        <pc:spChg chg="add mod">
          <ac:chgData name="Marta Estrela" userId="7250bf76-ff25-4d45-9f12-2372feb540ff" providerId="ADAL" clId="{EEE5B2BF-388B-469A-9BEE-C92C11703481}" dt="2021-08-20T21:07:20.251" v="803" actId="20577"/>
          <ac:spMkLst>
            <pc:docMk/>
            <pc:sldMk cId="164020171" sldId="267"/>
            <ac:spMk id="10" creationId="{352F1463-7EC8-447E-ACE8-FBA6053DBE10}"/>
          </ac:spMkLst>
        </pc:spChg>
        <pc:spChg chg="mod">
          <ac:chgData name="Marta Estrela" userId="7250bf76-ff25-4d45-9f12-2372feb540ff" providerId="ADAL" clId="{EEE5B2BF-388B-469A-9BEE-C92C11703481}" dt="2021-08-20T20:59:18.886" v="106" actId="207"/>
          <ac:spMkLst>
            <pc:docMk/>
            <pc:sldMk cId="164020171" sldId="267"/>
            <ac:spMk id="23" creationId="{A4006BFC-BA99-4B99-B51F-401E511FEBF0}"/>
          </ac:spMkLst>
        </pc:spChg>
        <pc:spChg chg="del">
          <ac:chgData name="Marta Estrela" userId="7250bf76-ff25-4d45-9f12-2372feb540ff" providerId="ADAL" clId="{EEE5B2BF-388B-469A-9BEE-C92C11703481}" dt="2021-08-20T20:59:10.993" v="101" actId="478"/>
          <ac:spMkLst>
            <pc:docMk/>
            <pc:sldMk cId="164020171" sldId="267"/>
            <ac:spMk id="35" creationId="{C51DA028-FE4D-4AD5-9C86-A9E91FFE3914}"/>
          </ac:spMkLst>
        </pc:spChg>
        <pc:spChg chg="mod">
          <ac:chgData name="Marta Estrela" userId="7250bf76-ff25-4d45-9f12-2372feb540ff" providerId="ADAL" clId="{EEE5B2BF-388B-469A-9BEE-C92C11703481}" dt="2021-08-20T20:59:32.643" v="110" actId="1076"/>
          <ac:spMkLst>
            <pc:docMk/>
            <pc:sldMk cId="164020171" sldId="267"/>
            <ac:spMk id="37" creationId="{1857D528-0445-49D7-9846-BDD5EA174D7B}"/>
          </ac:spMkLst>
        </pc:spChg>
        <pc:picChg chg="add mod ord">
          <ac:chgData name="Marta Estrela" userId="7250bf76-ff25-4d45-9f12-2372feb540ff" providerId="ADAL" clId="{EEE5B2BF-388B-469A-9BEE-C92C11703481}" dt="2021-08-20T20:58:25.600" v="84" actId="171"/>
          <ac:picMkLst>
            <pc:docMk/>
            <pc:sldMk cId="164020171" sldId="267"/>
            <ac:picMk id="9" creationId="{AF1FB6FB-5F99-491F-ADC8-457EA8BFF232}"/>
          </ac:picMkLst>
        </pc:picChg>
        <pc:picChg chg="del">
          <ac:chgData name="Marta Estrela" userId="7250bf76-ff25-4d45-9f12-2372feb540ff" providerId="ADAL" clId="{EEE5B2BF-388B-469A-9BEE-C92C11703481}" dt="2021-08-20T20:58:17.022" v="79" actId="478"/>
          <ac:picMkLst>
            <pc:docMk/>
            <pc:sldMk cId="164020171" sldId="267"/>
            <ac:picMk id="12" creationId="{355E00D1-4653-4907-B36C-C4F0F028DA2F}"/>
          </ac:picMkLst>
        </pc:picChg>
      </pc:sldChg>
      <pc:sldChg chg="addSp delSp add del setBg delDesignElem">
        <pc:chgData name="Marta Estrela" userId="7250bf76-ff25-4d45-9f12-2372feb540ff" providerId="ADAL" clId="{EEE5B2BF-388B-469A-9BEE-C92C11703481}" dt="2021-08-20T20:56:58.111" v="56"/>
        <pc:sldMkLst>
          <pc:docMk/>
          <pc:sldMk cId="2807445395" sldId="267"/>
        </pc:sldMkLst>
        <pc:spChg chg="add del">
          <ac:chgData name="Marta Estrela" userId="7250bf76-ff25-4d45-9f12-2372feb540ff" providerId="ADAL" clId="{EEE5B2BF-388B-469A-9BEE-C92C11703481}" dt="2021-08-20T20:56:58.111" v="56"/>
          <ac:spMkLst>
            <pc:docMk/>
            <pc:sldMk cId="2807445395" sldId="267"/>
            <ac:spMk id="49" creationId="{32BC26D8-82FB-445E-AA49-62A77D7C1EE0}"/>
          </ac:spMkLst>
        </pc:spChg>
        <pc:spChg chg="add del">
          <ac:chgData name="Marta Estrela" userId="7250bf76-ff25-4d45-9f12-2372feb540ff" providerId="ADAL" clId="{EEE5B2BF-388B-469A-9BEE-C92C11703481}" dt="2021-08-20T20:56:58.111" v="56"/>
          <ac:spMkLst>
            <pc:docMk/>
            <pc:sldMk cId="2807445395" sldId="267"/>
            <ac:spMk id="51" creationId="{CB44330D-EA18-4254-AA95-EB49948539B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2168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215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546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1561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3498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5448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3424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3858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282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505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277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11C91-D1BF-4B45-81C3-7066ABEC7A62}" type="datetimeFigureOut">
              <a:rPr lang="en-GB" smtClean="0"/>
              <a:t>20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EC1C1-65FC-4A01-8718-167AF1A175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2250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34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6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B4BF057-EA90-448B-901C-05AE0C42A991}"/>
              </a:ext>
            </a:extLst>
          </p:cNvPr>
          <p:cNvGrpSpPr/>
          <p:nvPr/>
        </p:nvGrpSpPr>
        <p:grpSpPr>
          <a:xfrm>
            <a:off x="665555" y="659547"/>
            <a:ext cx="10860890" cy="5554987"/>
            <a:chOff x="1420" y="165638"/>
            <a:chExt cx="6073660" cy="3197619"/>
          </a:xfrm>
        </p:grpSpPr>
        <p:pic>
          <p:nvPicPr>
            <p:cNvPr id="5" name="Picture 4" descr="Graphical user interface, website&#10;&#10;Description automatically generated">
              <a:extLst>
                <a:ext uri="{FF2B5EF4-FFF2-40B4-BE49-F238E27FC236}">
                  <a16:creationId xmlns:a16="http://schemas.microsoft.com/office/drawing/2014/main" id="{C9380676-FF0D-47F8-9CDD-44213D3EBF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20" y="165638"/>
              <a:ext cx="6073660" cy="3052013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4F1585E-224B-4471-AB59-864DC7B9347D}"/>
                </a:ext>
              </a:extLst>
            </p:cNvPr>
            <p:cNvSpPr/>
            <p:nvPr/>
          </p:nvSpPr>
          <p:spPr>
            <a:xfrm>
              <a:off x="8812" y="2717054"/>
              <a:ext cx="553357" cy="64620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spcAft>
                  <a:spcPts val="600"/>
                </a:spcAft>
              </a:pPr>
              <a:r>
                <a:rPr lang="en-US" sz="5000" b="1" dirty="0">
                  <a:ln w="0"/>
                  <a:solidFill>
                    <a:srgbClr val="06D1B6"/>
                  </a:solidFill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Corbel" panose="020B0503020204020204" pitchFamily="34" charset="0"/>
                </a:rPr>
                <a:t>1)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EE16C3ED-B3E9-435F-85FE-21DF8E5EB9E4}"/>
                </a:ext>
              </a:extLst>
            </p:cNvPr>
            <p:cNvSpPr/>
            <p:nvPr/>
          </p:nvSpPr>
          <p:spPr>
            <a:xfrm>
              <a:off x="1061324" y="194265"/>
              <a:ext cx="269626" cy="215444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 dirty="0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a)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CDDA1624-1229-4770-BE59-1077DE950367}"/>
                </a:ext>
              </a:extLst>
            </p:cNvPr>
            <p:cNvSpPr/>
            <p:nvPr/>
          </p:nvSpPr>
          <p:spPr>
            <a:xfrm>
              <a:off x="1061324" y="2459356"/>
              <a:ext cx="274435" cy="215444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 dirty="0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b)</a:t>
              </a:r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E83C8FB5-6CF3-41FA-8D5B-62BC5B10AB89}"/>
              </a:ext>
            </a:extLst>
          </p:cNvPr>
          <p:cNvSpPr/>
          <p:nvPr/>
        </p:nvSpPr>
        <p:spPr>
          <a:xfrm>
            <a:off x="477012" y="6423063"/>
            <a:ext cx="9372382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Homepage. a) website header; b) funding information  </a:t>
            </a:r>
          </a:p>
        </p:txBody>
      </p:sp>
    </p:spTree>
    <p:extLst>
      <p:ext uri="{BB962C8B-B14F-4D97-AF65-F5344CB8AC3E}">
        <p14:creationId xmlns:p14="http://schemas.microsoft.com/office/powerpoint/2010/main" val="36398567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43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0B95B698-7486-4CD3-BD18-79EFA4A9159A}"/>
              </a:ext>
            </a:extLst>
          </p:cNvPr>
          <p:cNvGrpSpPr/>
          <p:nvPr/>
        </p:nvGrpSpPr>
        <p:grpSpPr>
          <a:xfrm>
            <a:off x="725732" y="643467"/>
            <a:ext cx="10740536" cy="5571065"/>
            <a:chOff x="678773" y="528208"/>
            <a:chExt cx="10962747" cy="5686326"/>
          </a:xfrm>
        </p:grpSpPr>
        <p:pic>
          <p:nvPicPr>
            <p:cNvPr id="7" name="Picture 6" descr="Graphical user interface, application, Teams&#10;&#10;Description automatically generated">
              <a:extLst>
                <a:ext uri="{FF2B5EF4-FFF2-40B4-BE49-F238E27FC236}">
                  <a16:creationId xmlns:a16="http://schemas.microsoft.com/office/drawing/2014/main" id="{4AF3076E-DD31-44BE-B219-2ECFA12D3B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80320" y="528208"/>
              <a:ext cx="10861200" cy="5430600"/>
            </a:xfrm>
            <a:prstGeom prst="rect">
              <a:avLst/>
            </a:prstGeom>
          </p:spPr>
        </p:pic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C8C0397E-32E4-4926-A96B-4437DF830B4C}"/>
                </a:ext>
              </a:extLst>
            </p:cNvPr>
            <p:cNvSpPr/>
            <p:nvPr/>
          </p:nvSpPr>
          <p:spPr>
            <a:xfrm>
              <a:off x="1328709" y="528208"/>
              <a:ext cx="394660" cy="4001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a)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2946FA2D-AF4D-447E-9E9D-10C6033C9FCF}"/>
                </a:ext>
              </a:extLst>
            </p:cNvPr>
            <p:cNvSpPr/>
            <p:nvPr/>
          </p:nvSpPr>
          <p:spPr>
            <a:xfrm>
              <a:off x="1334415" y="1130141"/>
              <a:ext cx="377027" cy="4001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c)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A68B8221-B2D5-4540-9B3E-6FA0EB1E3903}"/>
                </a:ext>
              </a:extLst>
            </p:cNvPr>
            <p:cNvSpPr/>
            <p:nvPr/>
          </p:nvSpPr>
          <p:spPr>
            <a:xfrm>
              <a:off x="1322489" y="4354831"/>
              <a:ext cx="400880" cy="4001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b)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D90DBF12-FA02-483A-B180-1055981C0536}"/>
                </a:ext>
              </a:extLst>
            </p:cNvPr>
            <p:cNvSpPr/>
            <p:nvPr/>
          </p:nvSpPr>
          <p:spPr>
            <a:xfrm>
              <a:off x="678773" y="5091933"/>
              <a:ext cx="989510" cy="1122601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spcAft>
                  <a:spcPts val="600"/>
                </a:spcAft>
              </a:pPr>
              <a:r>
                <a:rPr lang="en-US" sz="5000" b="1">
                  <a:ln w="0"/>
                  <a:solidFill>
                    <a:srgbClr val="06D1B6"/>
                  </a:solidFill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Corbel" panose="020B0503020204020204" pitchFamily="34" charset="0"/>
                </a:rPr>
                <a:t>2)</a:t>
              </a:r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8538F659-FB5B-4DDB-BA4D-0DF7D7551277}"/>
              </a:ext>
            </a:extLst>
          </p:cNvPr>
          <p:cNvSpPr/>
          <p:nvPr/>
        </p:nvSpPr>
        <p:spPr>
          <a:xfrm>
            <a:off x="477012" y="6423063"/>
            <a:ext cx="9372382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Login page. a) website header; b) funding information; c) login section  </a:t>
            </a:r>
          </a:p>
        </p:txBody>
      </p:sp>
    </p:spTree>
    <p:extLst>
      <p:ext uri="{BB962C8B-B14F-4D97-AF65-F5344CB8AC3E}">
        <p14:creationId xmlns:p14="http://schemas.microsoft.com/office/powerpoint/2010/main" val="135140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885CFBC-453D-43DA-A843-46B188C8D299}"/>
              </a:ext>
            </a:extLst>
          </p:cNvPr>
          <p:cNvGrpSpPr/>
          <p:nvPr/>
        </p:nvGrpSpPr>
        <p:grpSpPr>
          <a:xfrm>
            <a:off x="643467" y="647120"/>
            <a:ext cx="10905066" cy="5563760"/>
            <a:chOff x="665400" y="673154"/>
            <a:chExt cx="10861200" cy="5541380"/>
          </a:xfrm>
        </p:grpSpPr>
        <p:pic>
          <p:nvPicPr>
            <p:cNvPr id="6" name="Picture 5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id="{91CC455E-5E6A-4DE0-AE4C-1B03E81107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65400" y="673154"/>
              <a:ext cx="10861200" cy="5442020"/>
            </a:xfrm>
            <a:prstGeom prst="rect">
              <a:avLst/>
            </a:prstGeom>
          </p:spPr>
        </p:pic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3A9BDAB2-AC9D-4232-AF0F-9292E7253A41}"/>
                </a:ext>
              </a:extLst>
            </p:cNvPr>
            <p:cNvSpPr/>
            <p:nvPr/>
          </p:nvSpPr>
          <p:spPr>
            <a:xfrm>
              <a:off x="1782750" y="1330442"/>
              <a:ext cx="405880" cy="4001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d)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83855EAA-7BC4-4AD2-A4E0-774E43AE4F2D}"/>
                </a:ext>
              </a:extLst>
            </p:cNvPr>
            <p:cNvSpPr/>
            <p:nvPr/>
          </p:nvSpPr>
          <p:spPr>
            <a:xfrm>
              <a:off x="1798972" y="2806548"/>
              <a:ext cx="389658" cy="4001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e)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9237CD84-D6A2-4C15-8E5D-39825C6AA6E4}"/>
                </a:ext>
              </a:extLst>
            </p:cNvPr>
            <p:cNvSpPr/>
            <p:nvPr/>
          </p:nvSpPr>
          <p:spPr>
            <a:xfrm>
              <a:off x="1809102" y="3981783"/>
              <a:ext cx="353175" cy="4001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f)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BC9204D6-9469-4A28-8697-4E02D3A5C987}"/>
                </a:ext>
              </a:extLst>
            </p:cNvPr>
            <p:cNvSpPr/>
            <p:nvPr/>
          </p:nvSpPr>
          <p:spPr>
            <a:xfrm>
              <a:off x="678773" y="5091933"/>
              <a:ext cx="989510" cy="1122601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spcAft>
                  <a:spcPts val="600"/>
                </a:spcAft>
              </a:pPr>
              <a:r>
                <a:rPr lang="en-US" sz="5000" b="1">
                  <a:ln w="0"/>
                  <a:solidFill>
                    <a:srgbClr val="06D1B6"/>
                  </a:solidFill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Corbel" panose="020B0503020204020204" pitchFamily="34" charset="0"/>
                </a:rPr>
                <a:t>3)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41BCBF16-9A98-4D90-8D2B-45BE054A819F}"/>
                </a:ext>
              </a:extLst>
            </p:cNvPr>
            <p:cNvSpPr/>
            <p:nvPr/>
          </p:nvSpPr>
          <p:spPr>
            <a:xfrm>
              <a:off x="1798972" y="707990"/>
              <a:ext cx="394660" cy="40011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a)</a:t>
              </a:r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A5622E0D-A060-4A8E-94FA-A4D39E599F3D}"/>
              </a:ext>
            </a:extLst>
          </p:cNvPr>
          <p:cNvSpPr/>
          <p:nvPr/>
        </p:nvSpPr>
        <p:spPr>
          <a:xfrm>
            <a:off x="477012" y="6423063"/>
            <a:ext cx="9372382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Online course page. a) website header; d) module description; e) progress bar; f) online course modules</a:t>
            </a:r>
          </a:p>
        </p:txBody>
      </p:sp>
    </p:spTree>
    <p:extLst>
      <p:ext uri="{BB962C8B-B14F-4D97-AF65-F5344CB8AC3E}">
        <p14:creationId xmlns:p14="http://schemas.microsoft.com/office/powerpoint/2010/main" val="29965171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4">
                <a:lumMod val="0"/>
                <a:lumOff val="100000"/>
              </a:schemeClr>
            </a:gs>
            <a:gs pos="35000">
              <a:schemeClr val="accent4">
                <a:lumMod val="0"/>
                <a:lumOff val="100000"/>
              </a:schemeClr>
            </a:gs>
            <a:gs pos="100000">
              <a:schemeClr val="accent4">
                <a:lumMod val="100000"/>
              </a:schemeClr>
            </a:gs>
          </a:gsLst>
          <a:path path="circle">
            <a:fillToRect l="50000" t="-80000" r="50000" b="18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7B2247B-F944-4C6E-A1BD-4A21742A99E2}"/>
              </a:ext>
            </a:extLst>
          </p:cNvPr>
          <p:cNvGrpSpPr/>
          <p:nvPr/>
        </p:nvGrpSpPr>
        <p:grpSpPr>
          <a:xfrm>
            <a:off x="643467" y="658313"/>
            <a:ext cx="10905066" cy="5541373"/>
            <a:chOff x="6135090" y="3634050"/>
            <a:chExt cx="6042021" cy="3070233"/>
          </a:xfrm>
        </p:grpSpPr>
        <p:pic>
          <p:nvPicPr>
            <p:cNvPr id="11" name="Picture 10" descr="Graphical user interface, text, application&#10;&#10;Description automatically generated">
              <a:extLst>
                <a:ext uri="{FF2B5EF4-FFF2-40B4-BE49-F238E27FC236}">
                  <a16:creationId xmlns:a16="http://schemas.microsoft.com/office/drawing/2014/main" id="{4FEA127D-AC08-4787-A3A9-C3D52F56B7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135090" y="3634050"/>
              <a:ext cx="6042021" cy="3027108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A4006BFC-BA99-4B99-B51F-401E511FEBF0}"/>
                </a:ext>
              </a:extLst>
            </p:cNvPr>
            <p:cNvSpPr/>
            <p:nvPr/>
          </p:nvSpPr>
          <p:spPr>
            <a:xfrm>
              <a:off x="6215571" y="6058080"/>
              <a:ext cx="569388" cy="646203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spcAft>
                  <a:spcPts val="600"/>
                </a:spcAft>
              </a:pPr>
              <a:r>
                <a:rPr lang="en-US" sz="5000" b="1" dirty="0">
                  <a:ln w="0"/>
                  <a:solidFill>
                    <a:srgbClr val="06D1B6"/>
                  </a:solidFill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Corbel" panose="020B0503020204020204" pitchFamily="34" charset="0"/>
                </a:rPr>
                <a:t>4)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DB305E81-15CD-4C76-A546-8E4A2211736A}"/>
                </a:ext>
              </a:extLst>
            </p:cNvPr>
            <p:cNvSpPr/>
            <p:nvPr/>
          </p:nvSpPr>
          <p:spPr>
            <a:xfrm>
              <a:off x="7112584" y="3674510"/>
              <a:ext cx="269626" cy="215444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 dirty="0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a)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C51DA028-FE4D-4AD5-9C86-A9E91FFE3914}"/>
                </a:ext>
              </a:extLst>
            </p:cNvPr>
            <p:cNvSpPr/>
            <p:nvPr/>
          </p:nvSpPr>
          <p:spPr>
            <a:xfrm>
              <a:off x="7118996" y="4094009"/>
              <a:ext cx="272832" cy="215444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g)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688667CD-C7EF-42D1-99E7-B28605B17AAF}"/>
                </a:ext>
              </a:extLst>
            </p:cNvPr>
            <p:cNvSpPr/>
            <p:nvPr/>
          </p:nvSpPr>
          <p:spPr>
            <a:xfrm>
              <a:off x="7118199" y="5950358"/>
              <a:ext cx="274435" cy="215444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h)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1857D528-0445-49D7-9846-BDD5EA174D7B}"/>
                </a:ext>
              </a:extLst>
            </p:cNvPr>
            <p:cNvSpPr/>
            <p:nvPr/>
          </p:nvSpPr>
          <p:spPr>
            <a:xfrm>
              <a:off x="7133426" y="6369857"/>
              <a:ext cx="242374" cy="215444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normAutofit/>
            </a:bodyPr>
            <a:lstStyle/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US" sz="2000" b="1">
                  <a:ln w="0"/>
                  <a:solidFill>
                    <a:srgbClr val="06D1B6"/>
                  </a:solidFill>
                  <a:latin typeface="Corbel" panose="020B0503020204020204" pitchFamily="34" charset="0"/>
                </a:rPr>
                <a:t>i)</a:t>
              </a:r>
            </a:p>
          </p:txBody>
        </p:sp>
        <p:pic>
          <p:nvPicPr>
            <p:cNvPr id="10" name="Picture 9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id="{A471FFF3-F72E-493B-B40D-2ACAF4DEAF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519375" y="3906692"/>
              <a:ext cx="3677161" cy="2771836"/>
            </a:xfrm>
            <a:prstGeom prst="rect">
              <a:avLst/>
            </a:prstGeom>
          </p:spPr>
        </p:pic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75E376B0-2A70-4A9E-A099-91C3BE873C7F}"/>
              </a:ext>
            </a:extLst>
          </p:cNvPr>
          <p:cNvSpPr/>
          <p:nvPr/>
        </p:nvSpPr>
        <p:spPr>
          <a:xfrm>
            <a:off x="477011" y="6423063"/>
            <a:ext cx="11237975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Module page example. a) website header; g) presentation; h) “mark as completed” and “download module” buttons; </a:t>
            </a:r>
            <a:r>
              <a:rPr lang="en-US" sz="1200" b="1" dirty="0" err="1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i</a:t>
            </a: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) previous/next module buttons</a:t>
            </a:r>
          </a:p>
        </p:txBody>
      </p:sp>
    </p:spTree>
    <p:extLst>
      <p:ext uri="{BB962C8B-B14F-4D97-AF65-F5344CB8AC3E}">
        <p14:creationId xmlns:p14="http://schemas.microsoft.com/office/powerpoint/2010/main" val="30878120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4">
                <a:lumMod val="0"/>
                <a:lumOff val="100000"/>
              </a:schemeClr>
            </a:gs>
            <a:gs pos="35000">
              <a:schemeClr val="accent4">
                <a:lumMod val="0"/>
                <a:lumOff val="100000"/>
              </a:schemeClr>
            </a:gs>
            <a:gs pos="100000">
              <a:schemeClr val="accent4">
                <a:lumMod val="100000"/>
              </a:schemeClr>
            </a:gs>
          </a:gsLst>
          <a:path path="circle">
            <a:fillToRect l="50000" t="-80000" r="50000" b="18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11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355E00D1-4653-4907-B36C-C4F0F028DA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" r="2" b="4490"/>
          <a:stretch/>
        </p:blipFill>
        <p:spPr>
          <a:xfrm>
            <a:off x="643467" y="731338"/>
            <a:ext cx="10905066" cy="5204996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A4006BFC-BA99-4B99-B51F-401E511FEBF0}"/>
              </a:ext>
            </a:extLst>
          </p:cNvPr>
          <p:cNvSpPr/>
          <p:nvPr/>
        </p:nvSpPr>
        <p:spPr>
          <a:xfrm>
            <a:off x="788725" y="5033373"/>
            <a:ext cx="1027672" cy="1166313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spcAft>
                <a:spcPts val="600"/>
              </a:spcAft>
            </a:pPr>
            <a:r>
              <a:rPr lang="en-US" sz="5000" b="1" dirty="0">
                <a:ln w="0"/>
                <a:solidFill>
                  <a:srgbClr val="06D1B6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Corbel" panose="020B0503020204020204" pitchFamily="34" charset="0"/>
              </a:rPr>
              <a:t>5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B305E81-15CD-4C76-A546-8E4A2211736A}"/>
              </a:ext>
            </a:extLst>
          </p:cNvPr>
          <p:cNvSpPr/>
          <p:nvPr/>
        </p:nvSpPr>
        <p:spPr>
          <a:xfrm>
            <a:off x="2407717" y="731338"/>
            <a:ext cx="486640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a)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51DA028-FE4D-4AD5-9C86-A9E91FFE3914}"/>
              </a:ext>
            </a:extLst>
          </p:cNvPr>
          <p:cNvSpPr/>
          <p:nvPr/>
        </p:nvSpPr>
        <p:spPr>
          <a:xfrm>
            <a:off x="2390362" y="1405822"/>
            <a:ext cx="492426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j)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857D528-0445-49D7-9846-BDD5EA174D7B}"/>
              </a:ext>
            </a:extLst>
          </p:cNvPr>
          <p:cNvSpPr/>
          <p:nvPr/>
        </p:nvSpPr>
        <p:spPr>
          <a:xfrm>
            <a:off x="2417848" y="3584410"/>
            <a:ext cx="437454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k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C589F11-A7D4-4E22-89C5-D6303A325265}"/>
              </a:ext>
            </a:extLst>
          </p:cNvPr>
          <p:cNvSpPr/>
          <p:nvPr/>
        </p:nvSpPr>
        <p:spPr>
          <a:xfrm>
            <a:off x="477011" y="6423063"/>
            <a:ext cx="11237975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Project information page. a) website header; j) “About the project”; k) </a:t>
            </a:r>
            <a:r>
              <a:rPr lang="en-US" sz="1200" b="1" dirty="0" err="1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eHealthResp</a:t>
            </a: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 project description</a:t>
            </a:r>
          </a:p>
        </p:txBody>
      </p:sp>
    </p:spTree>
    <p:extLst>
      <p:ext uri="{BB962C8B-B14F-4D97-AF65-F5344CB8AC3E}">
        <p14:creationId xmlns:p14="http://schemas.microsoft.com/office/powerpoint/2010/main" val="28055104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4">
                <a:lumMod val="0"/>
                <a:lumOff val="100000"/>
              </a:schemeClr>
            </a:gs>
            <a:gs pos="35000">
              <a:schemeClr val="accent4">
                <a:lumMod val="0"/>
                <a:lumOff val="100000"/>
              </a:schemeClr>
            </a:gs>
            <a:gs pos="100000">
              <a:schemeClr val="accent4">
                <a:lumMod val="100000"/>
              </a:schemeClr>
            </a:gs>
          </a:gsLst>
          <a:path path="circle">
            <a:fillToRect l="50000" t="-80000" r="50000" b="18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Graphical user interface, website&#10;&#10;Description automatically generated">
            <a:extLst>
              <a:ext uri="{FF2B5EF4-FFF2-40B4-BE49-F238E27FC236}">
                <a16:creationId xmlns:a16="http://schemas.microsoft.com/office/drawing/2014/main" id="{87B56063-5ACD-4220-9E6E-E9EBAFA60F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4" r="-3" b="4444"/>
          <a:stretch/>
        </p:blipFill>
        <p:spPr>
          <a:xfrm>
            <a:off x="643467" y="818603"/>
            <a:ext cx="10905066" cy="5176200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A4006BFC-BA99-4B99-B51F-401E511FEBF0}"/>
              </a:ext>
            </a:extLst>
          </p:cNvPr>
          <p:cNvSpPr/>
          <p:nvPr/>
        </p:nvSpPr>
        <p:spPr>
          <a:xfrm>
            <a:off x="788725" y="5033373"/>
            <a:ext cx="1027672" cy="1166313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spcAft>
                <a:spcPts val="600"/>
              </a:spcAft>
            </a:pPr>
            <a:r>
              <a:rPr lang="en-US" sz="5000" b="1" dirty="0">
                <a:ln w="0"/>
                <a:solidFill>
                  <a:srgbClr val="06D1B6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Corbel" panose="020B0503020204020204" pitchFamily="34" charset="0"/>
              </a:rPr>
              <a:t>6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B305E81-15CD-4C76-A546-8E4A2211736A}"/>
              </a:ext>
            </a:extLst>
          </p:cNvPr>
          <p:cNvSpPr/>
          <p:nvPr/>
        </p:nvSpPr>
        <p:spPr>
          <a:xfrm>
            <a:off x="2407717" y="731338"/>
            <a:ext cx="486640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a)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51DA028-FE4D-4AD5-9C86-A9E91FFE3914}"/>
              </a:ext>
            </a:extLst>
          </p:cNvPr>
          <p:cNvSpPr/>
          <p:nvPr/>
        </p:nvSpPr>
        <p:spPr>
          <a:xfrm>
            <a:off x="2390362" y="1405822"/>
            <a:ext cx="492426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n)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857D528-0445-49D7-9846-BDD5EA174D7B}"/>
              </a:ext>
            </a:extLst>
          </p:cNvPr>
          <p:cNvSpPr/>
          <p:nvPr/>
        </p:nvSpPr>
        <p:spPr>
          <a:xfrm>
            <a:off x="2432310" y="4868905"/>
            <a:ext cx="437454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o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8E5A999-ECFD-420B-896C-987FF39B5820}"/>
              </a:ext>
            </a:extLst>
          </p:cNvPr>
          <p:cNvSpPr/>
          <p:nvPr/>
        </p:nvSpPr>
        <p:spPr>
          <a:xfrm>
            <a:off x="477011" y="6423063"/>
            <a:ext cx="11237975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Publications page. a) website header; n) publications section; o) contact’s section hyperlink</a:t>
            </a:r>
          </a:p>
        </p:txBody>
      </p:sp>
    </p:spTree>
    <p:extLst>
      <p:ext uri="{BB962C8B-B14F-4D97-AF65-F5344CB8AC3E}">
        <p14:creationId xmlns:p14="http://schemas.microsoft.com/office/powerpoint/2010/main" val="13072837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4">
                <a:lumMod val="0"/>
                <a:lumOff val="100000"/>
              </a:schemeClr>
            </a:gs>
            <a:gs pos="35000">
              <a:schemeClr val="accent4">
                <a:lumMod val="0"/>
                <a:lumOff val="100000"/>
              </a:schemeClr>
            </a:gs>
            <a:gs pos="100000">
              <a:schemeClr val="accent4">
                <a:lumMod val="100000"/>
              </a:schemeClr>
            </a:gs>
          </a:gsLst>
          <a:path path="circle">
            <a:fillToRect l="50000" t="-80000" r="50000" b="18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Graphical user interface, application, Teams&#10;&#10;Description automatically generated">
            <a:extLst>
              <a:ext uri="{FF2B5EF4-FFF2-40B4-BE49-F238E27FC236}">
                <a16:creationId xmlns:a16="http://schemas.microsoft.com/office/drawing/2014/main" id="{4EE20DFD-A444-420D-983B-7C2155B76E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94" r="2" b="2"/>
          <a:stretch/>
        </p:blipFill>
        <p:spPr>
          <a:xfrm>
            <a:off x="643467" y="803444"/>
            <a:ext cx="10905066" cy="5251112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A4006BFC-BA99-4B99-B51F-401E511FEBF0}"/>
              </a:ext>
            </a:extLst>
          </p:cNvPr>
          <p:cNvSpPr/>
          <p:nvPr/>
        </p:nvSpPr>
        <p:spPr>
          <a:xfrm>
            <a:off x="788725" y="5033373"/>
            <a:ext cx="1027672" cy="1166313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spcAft>
                <a:spcPts val="600"/>
              </a:spcAft>
            </a:pPr>
            <a:r>
              <a:rPr lang="en-US" sz="5000" b="1" dirty="0">
                <a:ln w="0"/>
                <a:solidFill>
                  <a:srgbClr val="06D1B6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Corbel" panose="020B0503020204020204" pitchFamily="34" charset="0"/>
              </a:rPr>
              <a:t>7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B305E81-15CD-4C76-A546-8E4A2211736A}"/>
              </a:ext>
            </a:extLst>
          </p:cNvPr>
          <p:cNvSpPr/>
          <p:nvPr/>
        </p:nvSpPr>
        <p:spPr>
          <a:xfrm>
            <a:off x="2407717" y="731338"/>
            <a:ext cx="486640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a)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51DA028-FE4D-4AD5-9C86-A9E91FFE3914}"/>
              </a:ext>
            </a:extLst>
          </p:cNvPr>
          <p:cNvSpPr/>
          <p:nvPr/>
        </p:nvSpPr>
        <p:spPr>
          <a:xfrm>
            <a:off x="2362876" y="1675788"/>
            <a:ext cx="492426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p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3A62357-3E25-4E09-8D9D-EBC465EBF4A4}"/>
              </a:ext>
            </a:extLst>
          </p:cNvPr>
          <p:cNvSpPr/>
          <p:nvPr/>
        </p:nvSpPr>
        <p:spPr>
          <a:xfrm>
            <a:off x="643467" y="5921829"/>
            <a:ext cx="1481424" cy="2048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B999F02-136E-4F57-9568-2FE1652E4F92}"/>
              </a:ext>
            </a:extLst>
          </p:cNvPr>
          <p:cNvSpPr/>
          <p:nvPr/>
        </p:nvSpPr>
        <p:spPr>
          <a:xfrm>
            <a:off x="477011" y="6423063"/>
            <a:ext cx="11237975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Contacts page. a) website header; p) contact form</a:t>
            </a:r>
          </a:p>
        </p:txBody>
      </p:sp>
    </p:spTree>
    <p:extLst>
      <p:ext uri="{BB962C8B-B14F-4D97-AF65-F5344CB8AC3E}">
        <p14:creationId xmlns:p14="http://schemas.microsoft.com/office/powerpoint/2010/main" val="28916860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4">
                <a:lumMod val="0"/>
                <a:lumOff val="100000"/>
              </a:schemeClr>
            </a:gs>
            <a:gs pos="35000">
              <a:schemeClr val="accent4">
                <a:lumMod val="0"/>
                <a:lumOff val="100000"/>
              </a:schemeClr>
            </a:gs>
            <a:gs pos="100000">
              <a:schemeClr val="accent4">
                <a:lumMod val="100000"/>
              </a:schemeClr>
            </a:gs>
          </a:gsLst>
          <a:path path="circle">
            <a:fillToRect l="50000" t="-80000" r="50000" b="18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Graphical user interface&#10;&#10;Description automatically generated">
            <a:extLst>
              <a:ext uri="{FF2B5EF4-FFF2-40B4-BE49-F238E27FC236}">
                <a16:creationId xmlns:a16="http://schemas.microsoft.com/office/drawing/2014/main" id="{AF1FB6FB-5F99-491F-ADC8-457EA8BFF23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2" r="-3" b="-2"/>
          <a:stretch/>
        </p:blipFill>
        <p:spPr>
          <a:xfrm>
            <a:off x="643467" y="802319"/>
            <a:ext cx="10905066" cy="5253361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A4006BFC-BA99-4B99-B51F-401E511FEBF0}"/>
              </a:ext>
            </a:extLst>
          </p:cNvPr>
          <p:cNvSpPr/>
          <p:nvPr/>
        </p:nvSpPr>
        <p:spPr>
          <a:xfrm>
            <a:off x="788725" y="5033373"/>
            <a:ext cx="1027672" cy="1166313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spcAft>
                <a:spcPts val="600"/>
              </a:spcAft>
            </a:pPr>
            <a:r>
              <a:rPr lang="en-US" sz="5000" b="1" dirty="0">
                <a:ln w="0"/>
                <a:solidFill>
                  <a:schemeClr val="bg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Corbel" panose="020B0503020204020204" pitchFamily="34" charset="0"/>
              </a:rPr>
              <a:t>8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B305E81-15CD-4C76-A546-8E4A2211736A}"/>
              </a:ext>
            </a:extLst>
          </p:cNvPr>
          <p:cNvSpPr/>
          <p:nvPr/>
        </p:nvSpPr>
        <p:spPr>
          <a:xfrm>
            <a:off x="2407717" y="731338"/>
            <a:ext cx="486640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a)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857D528-0445-49D7-9846-BDD5EA174D7B}"/>
              </a:ext>
            </a:extLst>
          </p:cNvPr>
          <p:cNvSpPr/>
          <p:nvPr/>
        </p:nvSpPr>
        <p:spPr>
          <a:xfrm>
            <a:off x="2407717" y="2913850"/>
            <a:ext cx="437454" cy="388849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 algn="ctr">
              <a:lnSpc>
                <a:spcPct val="90000"/>
              </a:lnSpc>
              <a:spcAft>
                <a:spcPts val="600"/>
              </a:spcAft>
            </a:pPr>
            <a:r>
              <a:rPr lang="en-US" sz="2000" b="1" dirty="0">
                <a:ln w="0"/>
                <a:solidFill>
                  <a:schemeClr val="bg1"/>
                </a:solidFill>
                <a:latin typeface="Corbel" panose="020B0503020204020204" pitchFamily="34" charset="0"/>
              </a:rPr>
              <a:t>q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52F1463-7EC8-447E-ACE8-FBA6053DBE10}"/>
              </a:ext>
            </a:extLst>
          </p:cNvPr>
          <p:cNvSpPr/>
          <p:nvPr/>
        </p:nvSpPr>
        <p:spPr>
          <a:xfrm>
            <a:off x="477011" y="6423063"/>
            <a:ext cx="11237975" cy="374275"/>
          </a:xfrm>
          <a:prstGeom prst="rect">
            <a:avLst/>
          </a:prstGeom>
          <a:noFill/>
        </p:spPr>
        <p:txBody>
          <a:bodyPr wrap="none" lIns="91440" tIns="45720" rIns="91440" bIns="4572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Mobile app page. a) website header; q) mobile app description and hyperlink to </a:t>
            </a:r>
            <a:r>
              <a:rPr lang="en-US" sz="1200" b="1" dirty="0" err="1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PlayStore</a:t>
            </a:r>
            <a:r>
              <a:rPr lang="en-US" sz="1200" b="1" dirty="0">
                <a:ln w="0"/>
                <a:solidFill>
                  <a:srgbClr val="06D1B6"/>
                </a:solidFill>
                <a:latin typeface="Corbel" panose="020B0503020204020204" pitchFamily="34" charset="0"/>
              </a:rPr>
              <a:t> (Android) and AppStore (iOS)</a:t>
            </a:r>
          </a:p>
        </p:txBody>
      </p:sp>
    </p:spTree>
    <p:extLst>
      <p:ext uri="{BB962C8B-B14F-4D97-AF65-F5344CB8AC3E}">
        <p14:creationId xmlns:p14="http://schemas.microsoft.com/office/powerpoint/2010/main" val="164020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225</Words>
  <Application>Microsoft Office PowerPoint</Application>
  <PresentationFormat>Widescreen</PresentationFormat>
  <Paragraphs>39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orbe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a Estrela</dc:creator>
  <cp:lastModifiedBy>Marta Estrela</cp:lastModifiedBy>
  <cp:revision>2</cp:revision>
  <dcterms:created xsi:type="dcterms:W3CDTF">2021-06-02T10:28:40Z</dcterms:created>
  <dcterms:modified xsi:type="dcterms:W3CDTF">2021-08-20T21:07:27Z</dcterms:modified>
</cp:coreProperties>
</file>